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2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3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3" r:id="rId4"/>
    <p:sldId id="264" r:id="rId5"/>
    <p:sldId id="265" r:id="rId6"/>
    <p:sldId id="268" r:id="rId7"/>
    <p:sldId id="269" r:id="rId8"/>
    <p:sldId id="270" r:id="rId9"/>
    <p:sldId id="271" r:id="rId10"/>
  </p:sldIdLst>
  <p:sldSz cx="12192000" cy="6858000"/>
  <p:notesSz cx="7053263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78" y="12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011v2.bhp.org.bw\lab_research\Research%20Main\Research%20Lab-Venus\KAELO\PhD%20objectives\Nef\BCPP_nef.3PPTregion_5duplicates_removed_kks_17March2021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s011v2.bhp.org.bw\lab_research\Research%20Main\Research%20Lab-Venus\KAELO\PhD%20objectives\Nef\BCPP_nef.3PPTregion_5duplicates_removed_kks_17March202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s011v2.bhp.org.bw\lab_research\Research%20Main\Research%20Lab-Venus\KAELO\PhD%20objectives\Nef\BCPP_nef.3PPTregion_5duplicates_removed_kks_17March202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s011v2.bhp.org.bw\lab_research\Research%20Main\Research%20Lab-Venus\KAELO\PhD%20objectives\Nef\BCPP_nef.3PPTregion_5duplicates_removed_kks_17March2021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s011v2.bhp.org.bw\lab_research\Research%20Main\Research%20Lab-Venus\KAELO\PhD%20objectives\Nef\BCPP_nef.3PPTregion_5duplicates_removed_kks_17March2021.xlsx" TargetMode="Externa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s011v2.bhp.org.bw\lab_research\Research%20Main\Research%20Lab-Venus\KAELO\PhD%20objectives\Nef\BCPP_nef.3PPTregion_5duplicates_removed_kks_17March202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s011v2.bhp.org.bw\lab_research\Research%20Main\Research%20Lab-Venus\KAELO\PhD%20objectives\Nef\BCPP_nef.3PPTregion_5duplicates_removed_kks_17March2021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s011v2.bhp.org.bw\lab_research\Research%20Main\Research%20Lab-Venus\KAELO\PhD%20objectives\Nef\BCPP_nef.3PPTregion_5duplicates_removed_kks_17March2021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600" baseline="0">
                <a:solidFill>
                  <a:schemeClr val="tx1"/>
                </a:solidFill>
              </a:rPr>
              <a:t>HIV-1 nef 3'PPT HxB2 nucleotide positions</a:t>
            </a:r>
            <a:endParaRPr lang="en-US" sz="160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1711258616672181"/>
          <c:y val="4.42098946590997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836587538215849E-2"/>
          <c:y val="0.17423348517705134"/>
          <c:w val="0.8896650223620246"/>
          <c:h val="0.424009720692758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BCPP_nef.3PPTregion_5duplicates_removed_kks_17March2021.xlsx]all_together!$LB$6057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!$LC$6055:$LT$605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!$LC$6057:$LT$6057</c:f>
              <c:numCache>
                <c:formatCode>0.00%</c:formatCode>
                <c:ptCount val="18"/>
                <c:pt idx="0">
                  <c:v>6.6711140760506999E-4</c:v>
                </c:pt>
                <c:pt idx="1">
                  <c:v>1.667778519012675E-4</c:v>
                </c:pt>
                <c:pt idx="2">
                  <c:v>0.99933277731442871</c:v>
                </c:pt>
                <c:pt idx="3">
                  <c:v>0.99949966644429622</c:v>
                </c:pt>
                <c:pt idx="4">
                  <c:v>0.99716524929131234</c:v>
                </c:pt>
                <c:pt idx="5">
                  <c:v>0.99883294431477154</c:v>
                </c:pt>
                <c:pt idx="6">
                  <c:v>3.6672778796466078E-3</c:v>
                </c:pt>
                <c:pt idx="7">
                  <c:v>0.99883313885647607</c:v>
                </c:pt>
                <c:pt idx="8">
                  <c:v>0.996</c:v>
                </c:pt>
                <c:pt idx="9">
                  <c:v>0.99833333333333329</c:v>
                </c:pt>
                <c:pt idx="10">
                  <c:v>0.99750000000000005</c:v>
                </c:pt>
                <c:pt idx="11">
                  <c:v>1.0668444740790132E-2</c:v>
                </c:pt>
                <c:pt idx="12">
                  <c:v>3.8346115371790598E-3</c:v>
                </c:pt>
                <c:pt idx="13">
                  <c:v>2.0010005002501249E-3</c:v>
                </c:pt>
                <c:pt idx="14">
                  <c:v>8.5014169028171365E-3</c:v>
                </c:pt>
                <c:pt idx="15">
                  <c:v>2.6666666666666666E-3</c:v>
                </c:pt>
                <c:pt idx="16">
                  <c:v>8.3333333333333339E-4</c:v>
                </c:pt>
                <c:pt idx="17">
                  <c:v>0.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FE-4C48-B013-71F37713A6C7}"/>
            </c:ext>
          </c:extLst>
        </c:ser>
        <c:ser>
          <c:idx val="1"/>
          <c:order val="1"/>
          <c:tx>
            <c:strRef>
              <c:f>[BCPP_nef.3PPTregion_5duplicates_removed_kks_17March2021.xlsx]all_together!$LB$6058</c:f>
              <c:strCache>
                <c:ptCount val="1"/>
                <c:pt idx="0">
                  <c:v>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!$LC$6055:$LT$605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!$LC$6058:$LT$6058</c:f>
              <c:numCache>
                <c:formatCode>0.00%</c:formatCode>
                <c:ptCount val="18"/>
                <c:pt idx="0">
                  <c:v>0.99866577718478988</c:v>
                </c:pt>
                <c:pt idx="1">
                  <c:v>0.99966644429619744</c:v>
                </c:pt>
                <c:pt idx="2">
                  <c:v>1.6680567139282736E-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666944490748458E-4</c:v>
                </c:pt>
                <c:pt idx="7">
                  <c:v>0</c:v>
                </c:pt>
                <c:pt idx="8">
                  <c:v>2.6666666666666666E-3</c:v>
                </c:pt>
                <c:pt idx="9">
                  <c:v>1.6666666666666666E-4</c:v>
                </c:pt>
                <c:pt idx="10">
                  <c:v>3.3333333333333332E-4</c:v>
                </c:pt>
                <c:pt idx="11">
                  <c:v>1.5002500416736123E-3</c:v>
                </c:pt>
                <c:pt idx="12">
                  <c:v>1.6672224074691563E-4</c:v>
                </c:pt>
                <c:pt idx="13">
                  <c:v>0</c:v>
                </c:pt>
                <c:pt idx="14">
                  <c:v>1.666944490748458E-4</c:v>
                </c:pt>
                <c:pt idx="15">
                  <c:v>0</c:v>
                </c:pt>
                <c:pt idx="16">
                  <c:v>3.3333333333333332E-4</c:v>
                </c:pt>
                <c:pt idx="17">
                  <c:v>3.333333333333333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AFE-4C48-B013-71F37713A6C7}"/>
            </c:ext>
          </c:extLst>
        </c:ser>
        <c:ser>
          <c:idx val="2"/>
          <c:order val="2"/>
          <c:tx>
            <c:strRef>
              <c:f>[BCPP_nef.3PPTregion_5duplicates_removed_kks_17March2021.xlsx]all_together!$LB$6059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!$LC$6055:$LT$605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!$LC$6059:$LT$6059</c:f>
              <c:numCache>
                <c:formatCode>0.00%</c:formatCode>
                <c:ptCount val="18"/>
                <c:pt idx="0">
                  <c:v>1.667778519012675E-4</c:v>
                </c:pt>
                <c:pt idx="1">
                  <c:v>1.667778519012675E-4</c:v>
                </c:pt>
                <c:pt idx="2">
                  <c:v>3.3361134278565472E-4</c:v>
                </c:pt>
                <c:pt idx="3">
                  <c:v>3.33555703802535E-4</c:v>
                </c:pt>
                <c:pt idx="4">
                  <c:v>2.6680006670001667E-3</c:v>
                </c:pt>
                <c:pt idx="5">
                  <c:v>5.0016672224074694E-4</c:v>
                </c:pt>
                <c:pt idx="6">
                  <c:v>0.99566594432405398</c:v>
                </c:pt>
                <c:pt idx="7">
                  <c:v>3.3338889814969161E-4</c:v>
                </c:pt>
                <c:pt idx="8">
                  <c:v>0</c:v>
                </c:pt>
                <c:pt idx="9">
                  <c:v>8.3333333333333339E-4</c:v>
                </c:pt>
                <c:pt idx="10">
                  <c:v>1.5E-3</c:v>
                </c:pt>
                <c:pt idx="11">
                  <c:v>0.98733122187031175</c:v>
                </c:pt>
                <c:pt idx="12">
                  <c:v>0.99583194398132713</c:v>
                </c:pt>
                <c:pt idx="13">
                  <c:v>0.99783224945806237</c:v>
                </c:pt>
                <c:pt idx="14">
                  <c:v>0.99099849974995835</c:v>
                </c:pt>
                <c:pt idx="15">
                  <c:v>0.99716666666666665</c:v>
                </c:pt>
                <c:pt idx="16">
                  <c:v>0.99883333333333335</c:v>
                </c:pt>
                <c:pt idx="17">
                  <c:v>1.6666666666666666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AFE-4C48-B013-71F37713A6C7}"/>
            </c:ext>
          </c:extLst>
        </c:ser>
        <c:ser>
          <c:idx val="3"/>
          <c:order val="3"/>
          <c:tx>
            <c:strRef>
              <c:f>[BCPP_nef.3PPTregion_5duplicates_removed_kks_17March2021.xlsx]all_together!$LB$6060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!$LC$6055:$LT$605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!$LC$6060:$LT$6060</c:f>
              <c:numCache>
                <c:formatCode>0.00%</c:formatCode>
                <c:ptCount val="18"/>
                <c:pt idx="0">
                  <c:v>5.0033355570380258E-4</c:v>
                </c:pt>
                <c:pt idx="1">
                  <c:v>0</c:v>
                </c:pt>
                <c:pt idx="2">
                  <c:v>1.6680567139282736E-4</c:v>
                </c:pt>
                <c:pt idx="3">
                  <c:v>1.667778519012675E-4</c:v>
                </c:pt>
                <c:pt idx="4">
                  <c:v>1.6675004168751042E-4</c:v>
                </c:pt>
                <c:pt idx="5">
                  <c:v>6.6688896298766251E-4</c:v>
                </c:pt>
                <c:pt idx="6">
                  <c:v>5.0008334722453744E-4</c:v>
                </c:pt>
                <c:pt idx="7">
                  <c:v>8.33472245374229E-4</c:v>
                </c:pt>
                <c:pt idx="8">
                  <c:v>1.3333333333333333E-3</c:v>
                </c:pt>
                <c:pt idx="9">
                  <c:v>6.6666666666666664E-4</c:v>
                </c:pt>
                <c:pt idx="10">
                  <c:v>6.6666666666666664E-4</c:v>
                </c:pt>
                <c:pt idx="11">
                  <c:v>5.0008334722453744E-4</c:v>
                </c:pt>
                <c:pt idx="12">
                  <c:v>1.6672224074691563E-4</c:v>
                </c:pt>
                <c:pt idx="13">
                  <c:v>1.6675004168751042E-4</c:v>
                </c:pt>
                <c:pt idx="14">
                  <c:v>3.3338889814969161E-4</c:v>
                </c:pt>
                <c:pt idx="15">
                  <c:v>1.6666666666666666E-4</c:v>
                </c:pt>
                <c:pt idx="16">
                  <c:v>0</c:v>
                </c:pt>
                <c:pt idx="17">
                  <c:v>5.000000000000000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AFE-4C48-B013-71F37713A6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1618896"/>
        <c:axId val="671624800"/>
      </c:barChart>
      <c:catAx>
        <c:axId val="671618896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0" i="0" baseline="0" dirty="0">
                    <a:solidFill>
                      <a:schemeClr val="tx1"/>
                    </a:solidFill>
                    <a:effectLst/>
                  </a:rPr>
                  <a:t>figure S1: HIV-1C </a:t>
                </a:r>
                <a:r>
                  <a:rPr lang="en-US" sz="1400" b="0" i="1" baseline="0" dirty="0">
                    <a:solidFill>
                      <a:schemeClr val="tx1"/>
                    </a:solidFill>
                    <a:effectLst/>
                  </a:rPr>
                  <a:t>nef</a:t>
                </a:r>
                <a:r>
                  <a:rPr lang="en-US" sz="1400" b="0" i="0" baseline="0" dirty="0">
                    <a:solidFill>
                      <a:schemeClr val="tx1"/>
                    </a:solidFill>
                    <a:effectLst/>
                  </a:rPr>
                  <a:t> 3'PPT variability amongst sequences from individuals on cART and not on ART, n = 5959. </a:t>
                </a:r>
                <a:r>
                  <a:rPr lang="en-GB" sz="1400" b="0" i="0" u="none" strike="noStrike" baseline="0" dirty="0">
                    <a:effectLst/>
                  </a:rPr>
                  <a:t>cART, combination antiretroviral therapy; </a:t>
                </a:r>
                <a:r>
                  <a:rPr lang="en-US" sz="1400" b="0" i="0" u="none" strike="noStrike" baseline="0" dirty="0">
                    <a:effectLst/>
                  </a:rPr>
                  <a:t>3’PPT, 3’polypurine tract</a:t>
                </a:r>
                <a:endParaRPr lang="en-US" sz="1400" dirty="0"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>
                    <a:solidFill>
                      <a:schemeClr val="tx1"/>
                    </a:solidFill>
                  </a:defRPr>
                </a:pPr>
                <a:endParaRPr lang="en-US" sz="14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2.9413020464139145E-2"/>
              <c:y val="0.850222412645996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280000" spcFirstLastPara="1" vertOverflow="ellipsis" wrap="square" anchor="ctr" anchorCtr="0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1624800"/>
        <c:crosses val="autoZero"/>
        <c:auto val="1"/>
        <c:lblAlgn val="ctr"/>
        <c:lblOffset val="100"/>
        <c:tickMarkSkip val="1"/>
        <c:noMultiLvlLbl val="0"/>
      </c:catAx>
      <c:valAx>
        <c:axId val="671624800"/>
        <c:scaling>
          <c:orientation val="minMax"/>
          <c:max val="1"/>
        </c:scaling>
        <c:delete val="0"/>
        <c:axPos val="l"/>
        <c:majorGridlines>
          <c:spPr>
            <a:ln w="6350" cap="flat" cmpd="sng" algn="ctr">
              <a:solidFill>
                <a:schemeClr val="tx1">
                  <a:alpha val="31000"/>
                </a:schemeClr>
              </a:solidFill>
              <a:round/>
            </a:ln>
            <a:effectLst>
              <a:outerShdw dir="5400000" sx="1000" sy="1000" algn="ctr" rotWithShape="0">
                <a:schemeClr val="bg1"/>
              </a:outerShdw>
            </a:effectLst>
          </c:spPr>
        </c:majorGridlines>
        <c:numFmt formatCode="0.0%" sourceLinked="0"/>
        <c:majorTickMark val="out"/>
        <c:minorTickMark val="in"/>
        <c:tickLblPos val="nextTo"/>
        <c:spPr>
          <a:noFill/>
          <a:ln w="12700" cap="rnd" cmpd="sng">
            <a:solidFill>
              <a:schemeClr val="tx1">
                <a:alpha val="32000"/>
              </a:schemeClr>
            </a:solidFill>
          </a:ln>
          <a:effectLst>
            <a:glow>
              <a:schemeClr val="bg1">
                <a:alpha val="79000"/>
              </a:schemeClr>
            </a:glow>
            <a:outerShdw blurRad="25400" dist="50800" dir="5400000" algn="ctr" rotWithShape="0">
              <a:schemeClr val="bg1"/>
            </a:outerShdw>
          </a:effectLst>
        </c:spPr>
        <c:txPr>
          <a:bodyPr rot="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1618896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b="0" i="0" baseline="0">
                <a:solidFill>
                  <a:schemeClr val="tx1"/>
                </a:solidFill>
                <a:effectLst/>
              </a:rPr>
              <a:t>HIV-1 nef 3'PPT HxB2 nucleotide positions</a:t>
            </a:r>
            <a:endParaRPr lang="en-US" sz="1200"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>
                <a:solidFill>
                  <a:schemeClr val="tx1"/>
                </a:solidFill>
              </a:defRPr>
            </a:pPr>
            <a:endParaRPr lang="en-US" sz="120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2139255326753666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4938274254812548E-2"/>
          <c:y val="0.12638888888888888"/>
          <c:w val="0.93202468992478837"/>
          <c:h val="0.56658183756803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BCPP_nef.3PPTregion_5duplicates_removed_kks_17March2021.xlsx]ART naive n=1263'!$LB$131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ART naive n=1263'!$LC$1309:$LT$1310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ART naive n=1263'!$LC$1311:$LT$1311</c:f>
              <c:numCache>
                <c:formatCode>0.00%</c:formatCode>
                <c:ptCount val="18"/>
                <c:pt idx="0">
                  <c:v>0</c:v>
                </c:pt>
                <c:pt idx="1">
                  <c:v>7.9428117553613975E-4</c:v>
                </c:pt>
                <c:pt idx="2">
                  <c:v>0.9984114376489277</c:v>
                </c:pt>
                <c:pt idx="3">
                  <c:v>1</c:v>
                </c:pt>
                <c:pt idx="4">
                  <c:v>0.99523809523809526</c:v>
                </c:pt>
                <c:pt idx="5">
                  <c:v>0.99920634920634921</c:v>
                </c:pt>
                <c:pt idx="6">
                  <c:v>2.3809523809523812E-3</c:v>
                </c:pt>
                <c:pt idx="7">
                  <c:v>0.99920634920634921</c:v>
                </c:pt>
                <c:pt idx="8">
                  <c:v>0.99523809523809526</c:v>
                </c:pt>
                <c:pt idx="9">
                  <c:v>0.99920634920634921</c:v>
                </c:pt>
                <c:pt idx="10">
                  <c:v>0.99682539682539684</c:v>
                </c:pt>
                <c:pt idx="11">
                  <c:v>7.9365079365079361E-3</c:v>
                </c:pt>
                <c:pt idx="12">
                  <c:v>2.3809523809523812E-3</c:v>
                </c:pt>
                <c:pt idx="13">
                  <c:v>7.9428117553613975E-4</c:v>
                </c:pt>
                <c:pt idx="14">
                  <c:v>4.7619047619047623E-3</c:v>
                </c:pt>
                <c:pt idx="15">
                  <c:v>1.5873015873015873E-3</c:v>
                </c:pt>
                <c:pt idx="16">
                  <c:v>0</c:v>
                </c:pt>
                <c:pt idx="17">
                  <c:v>0.998412698412698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DA-405A-8402-CC5AF029833E}"/>
            </c:ext>
          </c:extLst>
        </c:ser>
        <c:ser>
          <c:idx val="1"/>
          <c:order val="1"/>
          <c:tx>
            <c:strRef>
              <c:f>'[BCPP_nef.3PPTregion_5duplicates_removed_kks_17March2021.xlsx]ART naive n=1263'!$LB$1312</c:f>
              <c:strCache>
                <c:ptCount val="1"/>
                <c:pt idx="0">
                  <c:v>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ART naive n=1263'!$LC$1309:$LT$1310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ART naive n=1263'!$LC$1312:$LT$1312</c:f>
              <c:numCache>
                <c:formatCode>0.00%</c:formatCode>
                <c:ptCount val="18"/>
                <c:pt idx="0">
                  <c:v>0.9984114376489277</c:v>
                </c:pt>
                <c:pt idx="1">
                  <c:v>0.99920571882446385</c:v>
                </c:pt>
                <c:pt idx="2">
                  <c:v>7.9428117553613975E-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1746031746031746E-3</c:v>
                </c:pt>
                <c:pt idx="9">
                  <c:v>0</c:v>
                </c:pt>
                <c:pt idx="10">
                  <c:v>7.9365079365079365E-4</c:v>
                </c:pt>
                <c:pt idx="11">
                  <c:v>1.5873015873015873E-3</c:v>
                </c:pt>
                <c:pt idx="12">
                  <c:v>7.9365079365079365E-4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7.9365079365079365E-4</c:v>
                </c:pt>
                <c:pt idx="17">
                  <c:v>7.9365079365079365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EDA-405A-8402-CC5AF029833E}"/>
            </c:ext>
          </c:extLst>
        </c:ser>
        <c:ser>
          <c:idx val="2"/>
          <c:order val="2"/>
          <c:tx>
            <c:strRef>
              <c:f>'[BCPP_nef.3PPTregion_5duplicates_removed_kks_17March2021.xlsx]ART naive n=1263'!$LB$1313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ART naive n=1263'!$LC$1309:$LT$1310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ART naive n=1263'!$LC$1313:$LT$1313</c:f>
              <c:numCache>
                <c:formatCode>0.00%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7.9428117553613975E-4</c:v>
                </c:pt>
                <c:pt idx="3">
                  <c:v>0</c:v>
                </c:pt>
                <c:pt idx="4">
                  <c:v>4.7619047619047623E-3</c:v>
                </c:pt>
                <c:pt idx="5">
                  <c:v>0</c:v>
                </c:pt>
                <c:pt idx="6">
                  <c:v>0.99682539682539684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7.9365079365079365E-4</c:v>
                </c:pt>
                <c:pt idx="11">
                  <c:v>0.98888888888888893</c:v>
                </c:pt>
                <c:pt idx="12">
                  <c:v>0.99682539682539684</c:v>
                </c:pt>
                <c:pt idx="13">
                  <c:v>0.99920571882446385</c:v>
                </c:pt>
                <c:pt idx="14">
                  <c:v>0.99444444444444446</c:v>
                </c:pt>
                <c:pt idx="15">
                  <c:v>0.99761904761904763</c:v>
                </c:pt>
                <c:pt idx="16">
                  <c:v>0.99920634920634921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EDA-405A-8402-CC5AF029833E}"/>
            </c:ext>
          </c:extLst>
        </c:ser>
        <c:ser>
          <c:idx val="3"/>
          <c:order val="3"/>
          <c:tx>
            <c:strRef>
              <c:f>'[BCPP_nef.3PPTregion_5duplicates_removed_kks_17March2021.xlsx]ART naive n=1263'!$LB$1314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ART naive n=1263'!$LC$1309:$LT$1310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ART naive n=1263'!$LC$1314:$LT$1314</c:f>
              <c:numCache>
                <c:formatCode>0.00%</c:formatCode>
                <c:ptCount val="18"/>
                <c:pt idx="0">
                  <c:v>1.5885623510722795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7.9365079365079365E-4</c:v>
                </c:pt>
                <c:pt idx="6">
                  <c:v>7.9365079365079365E-4</c:v>
                </c:pt>
                <c:pt idx="7">
                  <c:v>7.9365079365079365E-4</c:v>
                </c:pt>
                <c:pt idx="8">
                  <c:v>1.5873015873015873E-3</c:v>
                </c:pt>
                <c:pt idx="9">
                  <c:v>7.9365079365079365E-4</c:v>
                </c:pt>
                <c:pt idx="10">
                  <c:v>1.5873015873015873E-3</c:v>
                </c:pt>
                <c:pt idx="11">
                  <c:v>1.5873015873015873E-3</c:v>
                </c:pt>
                <c:pt idx="12">
                  <c:v>0</c:v>
                </c:pt>
                <c:pt idx="13">
                  <c:v>0</c:v>
                </c:pt>
                <c:pt idx="14">
                  <c:v>7.9365079365079365E-4</c:v>
                </c:pt>
                <c:pt idx="15">
                  <c:v>7.9365079365079365E-4</c:v>
                </c:pt>
                <c:pt idx="16">
                  <c:v>0</c:v>
                </c:pt>
                <c:pt idx="17">
                  <c:v>7.9365079365079365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EDA-405A-8402-CC5AF02983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02590056"/>
        <c:axId val="1102591040"/>
      </c:barChart>
      <c:catAx>
        <c:axId val="11025900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0" i="0" u="none" strike="noStrike" baseline="0" dirty="0">
                    <a:effectLst/>
                  </a:rPr>
                  <a:t>figure S2</a:t>
                </a:r>
                <a:r>
                  <a:rPr lang="en-US" sz="1100" b="0" i="0" baseline="0" dirty="0">
                    <a:solidFill>
                      <a:schemeClr val="tx1"/>
                    </a:solidFill>
                    <a:effectLst/>
                  </a:rPr>
                  <a:t>: HIV-1C </a:t>
                </a:r>
                <a:r>
                  <a:rPr lang="en-US" sz="1100" b="0" i="1" baseline="0" dirty="0">
                    <a:solidFill>
                      <a:schemeClr val="tx1"/>
                    </a:solidFill>
                    <a:effectLst/>
                  </a:rPr>
                  <a:t>nef</a:t>
                </a:r>
                <a:r>
                  <a:rPr lang="en-US" sz="1100" b="0" i="0" baseline="0" dirty="0">
                    <a:solidFill>
                      <a:schemeClr val="tx1"/>
                    </a:solidFill>
                    <a:effectLst/>
                  </a:rPr>
                  <a:t> 3'PPT variability amongst cART naive individuals, n = 1263 </a:t>
                </a:r>
                <a:endParaRPr lang="en-US" sz="1100" dirty="0"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>
                    <a:solidFill>
                      <a:schemeClr val="tx1"/>
                    </a:solidFill>
                  </a:defRPr>
                </a:pPr>
                <a:endParaRPr lang="en-US" sz="11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3.0013365528061543E-2"/>
              <c:y val="0.9209620256795205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2591040"/>
        <c:crosses val="autoZero"/>
        <c:auto val="1"/>
        <c:lblAlgn val="ctr"/>
        <c:lblOffset val="100"/>
        <c:noMultiLvlLbl val="0"/>
      </c:catAx>
      <c:valAx>
        <c:axId val="1102591040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2590056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baseline="0">
                <a:solidFill>
                  <a:schemeClr val="tx1"/>
                </a:solidFill>
                <a:effectLst/>
              </a:rPr>
              <a:t>HIV-1 nef 3'PPT HxB2 nucleotide positions</a:t>
            </a:r>
            <a:endParaRPr lang="en-US" sz="1400">
              <a:solidFill>
                <a:schemeClr val="tx1"/>
              </a:solidFill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1987475750313821E-2"/>
          <c:y val="0.13048376525703509"/>
          <c:w val="0.94804875613374417"/>
          <c:h val="0.482030615182244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BCPP_nef.3PPTregion_5duplicates_removed_kks_17March2021.xlsx]on ART_VL&lt;400 n=4483'!$LB$453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_VL&lt;400 n=4483'!$LC$4529:$LT$4530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_VL&lt;400 n=4483'!$LC$4531:$LT$4531</c:f>
              <c:numCache>
                <c:formatCode>0.00%</c:formatCode>
                <c:ptCount val="18"/>
                <c:pt idx="0">
                  <c:v>8.9345543890998434E-4</c:v>
                </c:pt>
                <c:pt idx="1">
                  <c:v>0</c:v>
                </c:pt>
                <c:pt idx="2">
                  <c:v>0.99955317247542452</c:v>
                </c:pt>
                <c:pt idx="3">
                  <c:v>0.99932990842081748</c:v>
                </c:pt>
                <c:pt idx="4">
                  <c:v>0.99776636140272501</c:v>
                </c:pt>
                <c:pt idx="5">
                  <c:v>0.99866011612326933</c:v>
                </c:pt>
                <c:pt idx="6">
                  <c:v>4.2420183076579592E-3</c:v>
                </c:pt>
                <c:pt idx="7">
                  <c:v>0.9988834301027244</c:v>
                </c:pt>
                <c:pt idx="8">
                  <c:v>0.99665103817816481</c:v>
                </c:pt>
                <c:pt idx="9">
                  <c:v>0.99821388702835456</c:v>
                </c:pt>
                <c:pt idx="10">
                  <c:v>0.99799062290689888</c:v>
                </c:pt>
                <c:pt idx="11">
                  <c:v>1.1389012952210809E-2</c:v>
                </c:pt>
                <c:pt idx="12">
                  <c:v>4.2439133348224261E-3</c:v>
                </c:pt>
                <c:pt idx="13">
                  <c:v>2.4570024570024569E-3</c:v>
                </c:pt>
                <c:pt idx="14">
                  <c:v>9.3812821085548365E-3</c:v>
                </c:pt>
                <c:pt idx="15">
                  <c:v>2.9030817329164806E-3</c:v>
                </c:pt>
                <c:pt idx="16">
                  <c:v>1.1165698972755694E-3</c:v>
                </c:pt>
                <c:pt idx="17">
                  <c:v>0.999330058061634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46-4F9B-8B2C-3A6BC3864AA3}"/>
            </c:ext>
          </c:extLst>
        </c:ser>
        <c:ser>
          <c:idx val="1"/>
          <c:order val="1"/>
          <c:tx>
            <c:strRef>
              <c:f>'[BCPP_nef.3PPTregion_5duplicates_removed_kks_17March2021.xlsx]on ART_VL&lt;400 n=4483'!$LB$4532</c:f>
              <c:strCache>
                <c:ptCount val="1"/>
                <c:pt idx="0">
                  <c:v>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_VL&lt;400 n=4483'!$LC$4529:$LT$4530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_VL&lt;400 n=4483'!$LC$4532:$LT$4532</c:f>
              <c:numCache>
                <c:formatCode>0.00%</c:formatCode>
                <c:ptCount val="18"/>
                <c:pt idx="0">
                  <c:v>0.99865981684163507</c:v>
                </c:pt>
                <c:pt idx="1">
                  <c:v>0.99977663614027246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2326412145568208E-4</c:v>
                </c:pt>
                <c:pt idx="7">
                  <c:v>0</c:v>
                </c:pt>
                <c:pt idx="8">
                  <c:v>2.2326412145568207E-3</c:v>
                </c:pt>
                <c:pt idx="9">
                  <c:v>2.2326412145568208E-4</c:v>
                </c:pt>
                <c:pt idx="10">
                  <c:v>2.2326412145568208E-4</c:v>
                </c:pt>
                <c:pt idx="11">
                  <c:v>1.5631978561857973E-3</c:v>
                </c:pt>
                <c:pt idx="12">
                  <c:v>0</c:v>
                </c:pt>
                <c:pt idx="13">
                  <c:v>0</c:v>
                </c:pt>
                <c:pt idx="14">
                  <c:v>2.2336385972749609E-4</c:v>
                </c:pt>
                <c:pt idx="15">
                  <c:v>0</c:v>
                </c:pt>
                <c:pt idx="16">
                  <c:v>0</c:v>
                </c:pt>
                <c:pt idx="17">
                  <c:v>2.2331397945511388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46-4F9B-8B2C-3A6BC3864AA3}"/>
            </c:ext>
          </c:extLst>
        </c:ser>
        <c:ser>
          <c:idx val="2"/>
          <c:order val="2"/>
          <c:tx>
            <c:strRef>
              <c:f>'[BCPP_nef.3PPTregion_5duplicates_removed_kks_17March2021.xlsx]on ART_VL&lt;400 n=4483'!$LB$4533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_VL&lt;400 n=4483'!$LC$4529:$LT$4530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_VL&lt;400 n=4483'!$LC$4533:$LT$4533</c:f>
              <c:numCache>
                <c:formatCode>0.00%</c:formatCode>
                <c:ptCount val="18"/>
                <c:pt idx="0">
                  <c:v>2.2336385972749609E-4</c:v>
                </c:pt>
                <c:pt idx="1">
                  <c:v>2.2336385972749609E-4</c:v>
                </c:pt>
                <c:pt idx="2">
                  <c:v>2.2341376228775692E-4</c:v>
                </c:pt>
                <c:pt idx="3">
                  <c:v>4.4672771945499217E-4</c:v>
                </c:pt>
                <c:pt idx="4">
                  <c:v>2.0102747375474648E-3</c:v>
                </c:pt>
                <c:pt idx="5">
                  <c:v>6.6994193836534166E-4</c:v>
                </c:pt>
                <c:pt idx="6">
                  <c:v>0.99508818932797505</c:v>
                </c:pt>
                <c:pt idx="7">
                  <c:v>2.2331397945511388E-4</c:v>
                </c:pt>
                <c:pt idx="8">
                  <c:v>0</c:v>
                </c:pt>
                <c:pt idx="9">
                  <c:v>8.9305648582272833E-4</c:v>
                </c:pt>
                <c:pt idx="10">
                  <c:v>1.5628488501897744E-3</c:v>
                </c:pt>
                <c:pt idx="11">
                  <c:v>0.98704778919160341</c:v>
                </c:pt>
                <c:pt idx="12">
                  <c:v>0.99553272280545013</c:v>
                </c:pt>
                <c:pt idx="13">
                  <c:v>0.99731963368327003</c:v>
                </c:pt>
                <c:pt idx="14">
                  <c:v>0.99039535403171763</c:v>
                </c:pt>
                <c:pt idx="15">
                  <c:v>0.99709691826708347</c:v>
                </c:pt>
                <c:pt idx="16">
                  <c:v>0.9988834301027244</c:v>
                </c:pt>
                <c:pt idx="17">
                  <c:v>2.2331397945511388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346-4F9B-8B2C-3A6BC3864AA3}"/>
            </c:ext>
          </c:extLst>
        </c:ser>
        <c:ser>
          <c:idx val="3"/>
          <c:order val="3"/>
          <c:tx>
            <c:strRef>
              <c:f>'[BCPP_nef.3PPTregion_5duplicates_removed_kks_17March2021.xlsx]on ART_VL&lt;400 n=4483'!$LB$4534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_VL&lt;400 n=4483'!$LC$4529:$LT$4530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_VL&lt;400 n=4483'!$LC$4534:$LT$4534</c:f>
              <c:numCache>
                <c:formatCode>0.00%</c:formatCode>
                <c:ptCount val="18"/>
                <c:pt idx="0">
                  <c:v>2.2336385972749609E-4</c:v>
                </c:pt>
                <c:pt idx="1">
                  <c:v>0</c:v>
                </c:pt>
                <c:pt idx="2">
                  <c:v>2.2341376228775692E-4</c:v>
                </c:pt>
                <c:pt idx="3">
                  <c:v>2.2336385972749609E-4</c:v>
                </c:pt>
                <c:pt idx="4">
                  <c:v>2.2336385972749609E-4</c:v>
                </c:pt>
                <c:pt idx="5">
                  <c:v>6.6994193836534166E-4</c:v>
                </c:pt>
                <c:pt idx="6">
                  <c:v>4.4652824291136416E-4</c:v>
                </c:pt>
                <c:pt idx="7">
                  <c:v>8.9325591782045551E-4</c:v>
                </c:pt>
                <c:pt idx="8">
                  <c:v>1.1163206072784104E-3</c:v>
                </c:pt>
                <c:pt idx="9">
                  <c:v>6.6979236436704619E-4</c:v>
                </c:pt>
                <c:pt idx="10">
                  <c:v>2.2326412145568208E-4</c:v>
                </c:pt>
                <c:pt idx="11">
                  <c:v>0</c:v>
                </c:pt>
                <c:pt idx="12">
                  <c:v>2.2336385972749609E-4</c:v>
                </c:pt>
                <c:pt idx="13">
                  <c:v>2.2336385972749609E-4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2.2331397945511388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346-4F9B-8B2C-3A6BC3864A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20639888"/>
        <c:axId val="1120636936"/>
      </c:barChart>
      <c:catAx>
        <c:axId val="11206398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0" i="0" u="none" strike="noStrike" baseline="0" dirty="0">
                    <a:effectLst/>
                  </a:rPr>
                  <a:t>figure S3: </a:t>
                </a:r>
                <a:r>
                  <a:rPr lang="en-US" sz="1400" b="0" i="0" baseline="0" dirty="0">
                    <a:solidFill>
                      <a:schemeClr val="tx1"/>
                    </a:solidFill>
                    <a:effectLst/>
                  </a:rPr>
                  <a:t>HIV-1C nef 3'PPT variability amongst individuals on ART with VL ≤ 400copies/mL, n = 4483</a:t>
                </a:r>
                <a:endParaRPr lang="en-US" sz="1400" dirty="0"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>
                    <a:solidFill>
                      <a:schemeClr val="tx1"/>
                    </a:solidFill>
                  </a:defRPr>
                </a:pPr>
                <a:endParaRPr lang="en-US" sz="14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2.6075259614287343E-2"/>
              <c:y val="0.904224162746548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0636936"/>
        <c:crosses val="autoZero"/>
        <c:auto val="1"/>
        <c:lblAlgn val="ctr"/>
        <c:lblOffset val="100"/>
        <c:noMultiLvlLbl val="0"/>
      </c:catAx>
      <c:valAx>
        <c:axId val="1120636936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0639888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600" baseline="0">
                <a:solidFill>
                  <a:schemeClr val="tx1"/>
                </a:solidFill>
              </a:rPr>
              <a:t>HIV-1 nef 3'PPT HxB2 nucleotide positions</a:t>
            </a:r>
            <a:endParaRPr lang="en-US" sz="160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1711258992428457"/>
          <c:y val="2.87088557907641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9278631513382978E-2"/>
          <c:y val="0.15873258821053846"/>
          <c:w val="0.90638855908242955"/>
          <c:h val="0.533760090019041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BCPP_nef.3PPTregion_5duplicates_removed_kks_17March2021.xlsx]all_together!$LB$6057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!$LC$6055:$LT$605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!$LC$6057:$LT$6057</c:f>
              <c:numCache>
                <c:formatCode>0.00%</c:formatCode>
                <c:ptCount val="18"/>
                <c:pt idx="0">
                  <c:v>6.6711140760506999E-4</c:v>
                </c:pt>
                <c:pt idx="1">
                  <c:v>1.667778519012675E-4</c:v>
                </c:pt>
                <c:pt idx="2">
                  <c:v>0.99933277731442871</c:v>
                </c:pt>
                <c:pt idx="3">
                  <c:v>0.99949966644429622</c:v>
                </c:pt>
                <c:pt idx="4">
                  <c:v>0.99716524929131234</c:v>
                </c:pt>
                <c:pt idx="5">
                  <c:v>0.99883294431477154</c:v>
                </c:pt>
                <c:pt idx="6">
                  <c:v>3.6672778796466078E-3</c:v>
                </c:pt>
                <c:pt idx="7">
                  <c:v>0.99883313885647607</c:v>
                </c:pt>
                <c:pt idx="8">
                  <c:v>0.996</c:v>
                </c:pt>
                <c:pt idx="9">
                  <c:v>0.99833333333333329</c:v>
                </c:pt>
                <c:pt idx="10">
                  <c:v>0.99750000000000005</c:v>
                </c:pt>
                <c:pt idx="11">
                  <c:v>1.0668444740790132E-2</c:v>
                </c:pt>
                <c:pt idx="12">
                  <c:v>3.8346115371790598E-3</c:v>
                </c:pt>
                <c:pt idx="13">
                  <c:v>2.0010005002501249E-3</c:v>
                </c:pt>
                <c:pt idx="14">
                  <c:v>8.5014169028171365E-3</c:v>
                </c:pt>
                <c:pt idx="15">
                  <c:v>2.6666666666666666E-3</c:v>
                </c:pt>
                <c:pt idx="16">
                  <c:v>8.3333333333333339E-4</c:v>
                </c:pt>
                <c:pt idx="17">
                  <c:v>0.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72-4A47-931F-2F91620A973F}"/>
            </c:ext>
          </c:extLst>
        </c:ser>
        <c:ser>
          <c:idx val="1"/>
          <c:order val="1"/>
          <c:tx>
            <c:strRef>
              <c:f>[BCPP_nef.3PPTregion_5duplicates_removed_kks_17March2021.xlsx]all_together!$LB$6058</c:f>
              <c:strCache>
                <c:ptCount val="1"/>
                <c:pt idx="0">
                  <c:v>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!$LC$6055:$LT$605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!$LC$6058:$LT$6058</c:f>
              <c:numCache>
                <c:formatCode>0.00%</c:formatCode>
                <c:ptCount val="18"/>
                <c:pt idx="0">
                  <c:v>0.99866577718478988</c:v>
                </c:pt>
                <c:pt idx="1">
                  <c:v>0.99966644429619744</c:v>
                </c:pt>
                <c:pt idx="2">
                  <c:v>1.6680567139282736E-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666944490748458E-4</c:v>
                </c:pt>
                <c:pt idx="7">
                  <c:v>0</c:v>
                </c:pt>
                <c:pt idx="8">
                  <c:v>2.6666666666666666E-3</c:v>
                </c:pt>
                <c:pt idx="9">
                  <c:v>1.6666666666666666E-4</c:v>
                </c:pt>
                <c:pt idx="10">
                  <c:v>3.3333333333333332E-4</c:v>
                </c:pt>
                <c:pt idx="11">
                  <c:v>1.5002500416736123E-3</c:v>
                </c:pt>
                <c:pt idx="12">
                  <c:v>1.6672224074691563E-4</c:v>
                </c:pt>
                <c:pt idx="13">
                  <c:v>0</c:v>
                </c:pt>
                <c:pt idx="14">
                  <c:v>1.666944490748458E-4</c:v>
                </c:pt>
                <c:pt idx="15">
                  <c:v>0</c:v>
                </c:pt>
                <c:pt idx="16">
                  <c:v>3.3333333333333332E-4</c:v>
                </c:pt>
                <c:pt idx="17">
                  <c:v>3.333333333333333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872-4A47-931F-2F91620A973F}"/>
            </c:ext>
          </c:extLst>
        </c:ser>
        <c:ser>
          <c:idx val="2"/>
          <c:order val="2"/>
          <c:tx>
            <c:strRef>
              <c:f>[BCPP_nef.3PPTregion_5duplicates_removed_kks_17March2021.xlsx]all_together!$LB$6059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!$LC$6055:$LT$605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!$LC$6059:$LT$6059</c:f>
              <c:numCache>
                <c:formatCode>0.00%</c:formatCode>
                <c:ptCount val="18"/>
                <c:pt idx="0">
                  <c:v>1.667778519012675E-4</c:v>
                </c:pt>
                <c:pt idx="1">
                  <c:v>1.667778519012675E-4</c:v>
                </c:pt>
                <c:pt idx="2">
                  <c:v>3.3361134278565472E-4</c:v>
                </c:pt>
                <c:pt idx="3">
                  <c:v>3.33555703802535E-4</c:v>
                </c:pt>
                <c:pt idx="4">
                  <c:v>2.6680006670001667E-3</c:v>
                </c:pt>
                <c:pt idx="5">
                  <c:v>5.0016672224074694E-4</c:v>
                </c:pt>
                <c:pt idx="6">
                  <c:v>0.99566594432405398</c:v>
                </c:pt>
                <c:pt idx="7">
                  <c:v>3.3338889814969161E-4</c:v>
                </c:pt>
                <c:pt idx="8">
                  <c:v>0</c:v>
                </c:pt>
                <c:pt idx="9">
                  <c:v>8.3333333333333339E-4</c:v>
                </c:pt>
                <c:pt idx="10">
                  <c:v>1.5E-3</c:v>
                </c:pt>
                <c:pt idx="11">
                  <c:v>0.98733122187031175</c:v>
                </c:pt>
                <c:pt idx="12">
                  <c:v>0.99583194398132713</c:v>
                </c:pt>
                <c:pt idx="13">
                  <c:v>0.99783224945806237</c:v>
                </c:pt>
                <c:pt idx="14">
                  <c:v>0.99099849974995835</c:v>
                </c:pt>
                <c:pt idx="15">
                  <c:v>0.99716666666666665</c:v>
                </c:pt>
                <c:pt idx="16">
                  <c:v>0.99883333333333335</c:v>
                </c:pt>
                <c:pt idx="17">
                  <c:v>1.6666666666666666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872-4A47-931F-2F91620A973F}"/>
            </c:ext>
          </c:extLst>
        </c:ser>
        <c:ser>
          <c:idx val="3"/>
          <c:order val="3"/>
          <c:tx>
            <c:strRef>
              <c:f>[BCPP_nef.3PPTregion_5duplicates_removed_kks_17March2021.xlsx]all_together!$LB$6060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!$LC$6055:$LT$605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!$LC$6060:$LT$6060</c:f>
              <c:numCache>
                <c:formatCode>0.00%</c:formatCode>
                <c:ptCount val="18"/>
                <c:pt idx="0">
                  <c:v>5.0033355570380258E-4</c:v>
                </c:pt>
                <c:pt idx="1">
                  <c:v>0</c:v>
                </c:pt>
                <c:pt idx="2">
                  <c:v>1.6680567139282736E-4</c:v>
                </c:pt>
                <c:pt idx="3">
                  <c:v>1.667778519012675E-4</c:v>
                </c:pt>
                <c:pt idx="4">
                  <c:v>1.6675004168751042E-4</c:v>
                </c:pt>
                <c:pt idx="5">
                  <c:v>6.6688896298766251E-4</c:v>
                </c:pt>
                <c:pt idx="6">
                  <c:v>5.0008334722453744E-4</c:v>
                </c:pt>
                <c:pt idx="7">
                  <c:v>8.33472245374229E-4</c:v>
                </c:pt>
                <c:pt idx="8">
                  <c:v>1.3333333333333333E-3</c:v>
                </c:pt>
                <c:pt idx="9">
                  <c:v>6.6666666666666664E-4</c:v>
                </c:pt>
                <c:pt idx="10">
                  <c:v>6.6666666666666664E-4</c:v>
                </c:pt>
                <c:pt idx="11">
                  <c:v>5.0008334722453744E-4</c:v>
                </c:pt>
                <c:pt idx="12">
                  <c:v>1.6672224074691563E-4</c:v>
                </c:pt>
                <c:pt idx="13">
                  <c:v>1.6675004168751042E-4</c:v>
                </c:pt>
                <c:pt idx="14">
                  <c:v>3.3338889814969161E-4</c:v>
                </c:pt>
                <c:pt idx="15">
                  <c:v>1.6666666666666666E-4</c:v>
                </c:pt>
                <c:pt idx="16">
                  <c:v>0</c:v>
                </c:pt>
                <c:pt idx="17">
                  <c:v>5.000000000000000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872-4A47-931F-2F91620A97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1618896"/>
        <c:axId val="671624800"/>
      </c:barChart>
      <c:catAx>
        <c:axId val="671618896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u="none" strike="noStrike" baseline="0" dirty="0">
                    <a:effectLst/>
                  </a:rPr>
                  <a:t>figure S4. </a:t>
                </a:r>
                <a:r>
                  <a:rPr lang="en-US" sz="1200" b="0" i="0" baseline="0" dirty="0">
                    <a:effectLst/>
                  </a:rPr>
                  <a:t>HIV-1C </a:t>
                </a:r>
                <a:r>
                  <a:rPr lang="en-US" sz="1200" b="0" i="1" baseline="0" dirty="0">
                    <a:effectLst/>
                  </a:rPr>
                  <a:t>nef</a:t>
                </a:r>
                <a:r>
                  <a:rPr lang="en-US" sz="1200" b="0" i="0" baseline="0" dirty="0">
                    <a:effectLst/>
                  </a:rPr>
                  <a:t> 3'PPT variability amongst individuals on ART with VL &gt; 400copies/mL , n = 213</a:t>
                </a:r>
                <a:endParaRPr lang="en-US" sz="12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>
                    <a:solidFill>
                      <a:sysClr val="windowText" lastClr="000000"/>
                    </a:solidFill>
                  </a:defRPr>
                </a:pPr>
                <a:r>
                  <a:rPr lang="en-US" sz="1200" b="0" i="0" baseline="0" dirty="0">
                    <a:solidFill>
                      <a:schemeClr val="tx1"/>
                    </a:solidFill>
                    <a:effectLst/>
                  </a:rPr>
                  <a:t> </a:t>
                </a:r>
                <a:endParaRPr lang="en-US" sz="1200" dirty="0"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>
                    <a:solidFill>
                      <a:sysClr val="windowText" lastClr="000000"/>
                    </a:solidFill>
                  </a:defRPr>
                </a:pPr>
                <a:endParaRPr lang="en-US" sz="12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1078612020182586E-2"/>
              <c:y val="0.8968396419531745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280000" spcFirstLastPara="1" vertOverflow="ellipsis" wrap="square" anchor="ctr" anchorCtr="0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1624800"/>
        <c:crosses val="autoZero"/>
        <c:auto val="1"/>
        <c:lblAlgn val="ctr"/>
        <c:lblOffset val="100"/>
        <c:tickMarkSkip val="1"/>
        <c:noMultiLvlLbl val="0"/>
      </c:catAx>
      <c:valAx>
        <c:axId val="671624800"/>
        <c:scaling>
          <c:orientation val="minMax"/>
          <c:max val="1"/>
        </c:scaling>
        <c:delete val="0"/>
        <c:axPos val="l"/>
        <c:majorGridlines>
          <c:spPr>
            <a:ln w="6350" cap="flat" cmpd="sng" algn="ctr">
              <a:solidFill>
                <a:schemeClr val="tx1">
                  <a:alpha val="31000"/>
                </a:schemeClr>
              </a:solidFill>
              <a:round/>
            </a:ln>
            <a:effectLst>
              <a:outerShdw dir="5400000" sx="1000" sy="1000" algn="ctr" rotWithShape="0">
                <a:schemeClr val="bg1"/>
              </a:outerShdw>
            </a:effectLst>
          </c:spPr>
        </c:majorGridlines>
        <c:numFmt formatCode="0.0%" sourceLinked="0"/>
        <c:majorTickMark val="out"/>
        <c:minorTickMark val="in"/>
        <c:tickLblPos val="nextTo"/>
        <c:spPr>
          <a:noFill/>
          <a:ln w="9525" cap="rnd" cmpd="sng">
            <a:solidFill>
              <a:schemeClr val="tx1">
                <a:alpha val="94000"/>
              </a:schemeClr>
            </a:solidFill>
          </a:ln>
          <a:effectLst>
            <a:glow>
              <a:schemeClr val="bg1">
                <a:alpha val="79000"/>
              </a:schemeClr>
            </a:glow>
            <a:outerShdw blurRad="25400" dist="50800" dir="5400000" algn="ctr" rotWithShape="0">
              <a:schemeClr val="bg1"/>
            </a:outerShdw>
          </a:effectLst>
        </c:spPr>
        <c:txPr>
          <a:bodyPr rot="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1618896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600" baseline="0">
                <a:solidFill>
                  <a:schemeClr val="tx1"/>
                </a:solidFill>
              </a:rPr>
              <a:t>HIV-1 nef 3'PPT HxB2 nucleotide positions</a:t>
            </a:r>
            <a:endParaRPr lang="en-US" sz="160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1711258616672181"/>
          <c:y val="4.42098946590997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162935616362087E-2"/>
          <c:y val="0.17423347704343969"/>
          <c:w val="0.8896650223620246"/>
          <c:h val="0.424009720692758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BCPP_nef.3PPTregion_5duplicates_removed_kks_17March2021.xlsx]all_together_hypermuts_removd!$LB$3040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_hypermuts_removd!$LC$3038:$LT$3039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_hypermuts_removd!$LC$3040:$LT$3040</c:f>
              <c:numCache>
                <c:formatCode>0.00%</c:formatCode>
                <c:ptCount val="18"/>
                <c:pt idx="0">
                  <c:v>3.348961821835231E-4</c:v>
                </c:pt>
                <c:pt idx="1">
                  <c:v>0</c:v>
                </c:pt>
                <c:pt idx="2">
                  <c:v>0.99933020763563296</c:v>
                </c:pt>
                <c:pt idx="3">
                  <c:v>0.99966510381781648</c:v>
                </c:pt>
                <c:pt idx="4">
                  <c:v>0.99866041527126592</c:v>
                </c:pt>
                <c:pt idx="5">
                  <c:v>0.99899531145344944</c:v>
                </c:pt>
                <c:pt idx="6">
                  <c:v>3.0130565785068631E-3</c:v>
                </c:pt>
                <c:pt idx="7">
                  <c:v>0.99933020763563296</c:v>
                </c:pt>
                <c:pt idx="8">
                  <c:v>0.99631737529293607</c:v>
                </c:pt>
                <c:pt idx="9">
                  <c:v>0.99866086374288587</c:v>
                </c:pt>
                <c:pt idx="10">
                  <c:v>0.99899564780716443</c:v>
                </c:pt>
                <c:pt idx="11">
                  <c:v>9.3770931011386473E-3</c:v>
                </c:pt>
                <c:pt idx="12">
                  <c:v>2.6791694574681848E-3</c:v>
                </c:pt>
                <c:pt idx="13">
                  <c:v>2.3450586264656616E-3</c:v>
                </c:pt>
                <c:pt idx="14">
                  <c:v>1.0716677829872739E-2</c:v>
                </c:pt>
                <c:pt idx="15">
                  <c:v>2.0087043856712419E-3</c:v>
                </c:pt>
                <c:pt idx="16">
                  <c:v>6.6956812855708072E-4</c:v>
                </c:pt>
                <c:pt idx="17">
                  <c:v>0.998995647807164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68-46C0-B78F-EA411D723685}"/>
            </c:ext>
          </c:extLst>
        </c:ser>
        <c:ser>
          <c:idx val="1"/>
          <c:order val="1"/>
          <c:tx>
            <c:strRef>
              <c:f>[BCPP_nef.3PPTregion_5duplicates_removed_kks_17March2021.xlsx]all_together_hypermuts_removd!$LB$3041</c:f>
              <c:strCache>
                <c:ptCount val="1"/>
                <c:pt idx="0">
                  <c:v>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_hypermuts_removd!$LC$3038:$LT$3039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_hypermuts_removd!$LC$3041:$LT$3041</c:f>
              <c:numCache>
                <c:formatCode>0.00%</c:formatCode>
                <c:ptCount val="18"/>
                <c:pt idx="0">
                  <c:v>0.99866041527126592</c:v>
                </c:pt>
                <c:pt idx="1">
                  <c:v>0.9996651038178164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.6782725142283229E-3</c:v>
                </c:pt>
                <c:pt idx="9">
                  <c:v>3.3478406427854036E-4</c:v>
                </c:pt>
                <c:pt idx="10">
                  <c:v>3.3478406427854036E-4</c:v>
                </c:pt>
                <c:pt idx="11">
                  <c:v>1.3395847287340924E-3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3.3478406427854036E-4</c:v>
                </c:pt>
                <c:pt idx="17">
                  <c:v>6.695681285570807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68-46C0-B78F-EA411D723685}"/>
            </c:ext>
          </c:extLst>
        </c:ser>
        <c:ser>
          <c:idx val="2"/>
          <c:order val="2"/>
          <c:tx>
            <c:strRef>
              <c:f>[BCPP_nef.3PPTregion_5duplicates_removed_kks_17March2021.xlsx]all_together_hypermuts_removd!$LB$3042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_hypermuts_removd!$LC$3038:$LT$3039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_hypermuts_removd!$LC$3042:$LT$3042</c:f>
              <c:numCache>
                <c:formatCode>0.00%</c:formatCode>
                <c:ptCount val="18"/>
                <c:pt idx="0">
                  <c:v>3.348961821835231E-4</c:v>
                </c:pt>
                <c:pt idx="1">
                  <c:v>3.348961821835231E-4</c:v>
                </c:pt>
                <c:pt idx="2">
                  <c:v>3.348961821835231E-4</c:v>
                </c:pt>
                <c:pt idx="3">
                  <c:v>3.348961821835231E-4</c:v>
                </c:pt>
                <c:pt idx="4">
                  <c:v>1.0046885465505692E-3</c:v>
                </c:pt>
                <c:pt idx="5">
                  <c:v>3.348961821835231E-4</c:v>
                </c:pt>
                <c:pt idx="6">
                  <c:v>0.99665215935721463</c:v>
                </c:pt>
                <c:pt idx="7">
                  <c:v>3.348961821835231E-4</c:v>
                </c:pt>
                <c:pt idx="8">
                  <c:v>0</c:v>
                </c:pt>
                <c:pt idx="9">
                  <c:v>3.3478406427854036E-4</c:v>
                </c:pt>
                <c:pt idx="10">
                  <c:v>6.6956812855708072E-4</c:v>
                </c:pt>
                <c:pt idx="11">
                  <c:v>0.98894842598794375</c:v>
                </c:pt>
                <c:pt idx="12">
                  <c:v>0.99732083054253184</c:v>
                </c:pt>
                <c:pt idx="13">
                  <c:v>0.99765494137353439</c:v>
                </c:pt>
                <c:pt idx="14">
                  <c:v>0.98928332217012727</c:v>
                </c:pt>
                <c:pt idx="15">
                  <c:v>0.9976565115500502</c:v>
                </c:pt>
                <c:pt idx="16">
                  <c:v>0.99899564780716443</c:v>
                </c:pt>
                <c:pt idx="17">
                  <c:v>3.3478406427854036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468-46C0-B78F-EA411D723685}"/>
            </c:ext>
          </c:extLst>
        </c:ser>
        <c:ser>
          <c:idx val="3"/>
          <c:order val="3"/>
          <c:tx>
            <c:strRef>
              <c:f>[BCPP_nef.3PPTregion_5duplicates_removed_kks_17March2021.xlsx]all_together_hypermuts_removd!$LB$3043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[BCPP_nef.3PPTregion_5duplicates_removed_kks_17March2021.xlsx]all_together_hypermuts_removd!$LC$3038:$LT$3039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[BCPP_nef.3PPTregion_5duplicates_removed_kks_17March2021.xlsx]all_together_hypermuts_removd!$LC$3043:$LT$3043</c:f>
              <c:numCache>
                <c:formatCode>0.00%</c:formatCode>
                <c:ptCount val="18"/>
                <c:pt idx="0">
                  <c:v>6.6979236436704619E-4</c:v>
                </c:pt>
                <c:pt idx="1">
                  <c:v>0</c:v>
                </c:pt>
                <c:pt idx="2">
                  <c:v>3.348961821835231E-4</c:v>
                </c:pt>
                <c:pt idx="3">
                  <c:v>0</c:v>
                </c:pt>
                <c:pt idx="4">
                  <c:v>3.348961821835231E-4</c:v>
                </c:pt>
                <c:pt idx="5">
                  <c:v>6.6979236436704619E-4</c:v>
                </c:pt>
                <c:pt idx="6">
                  <c:v>3.3478406427854036E-4</c:v>
                </c:pt>
                <c:pt idx="7">
                  <c:v>3.348961821835231E-4</c:v>
                </c:pt>
                <c:pt idx="8">
                  <c:v>1.004352192835621E-3</c:v>
                </c:pt>
                <c:pt idx="9">
                  <c:v>6.6956812855708072E-4</c:v>
                </c:pt>
                <c:pt idx="10">
                  <c:v>0</c:v>
                </c:pt>
                <c:pt idx="11">
                  <c:v>3.348961821835231E-4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3.3478406427854036E-4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468-46C0-B78F-EA411D7236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1618896"/>
        <c:axId val="671624800"/>
      </c:barChart>
      <c:catAx>
        <c:axId val="671618896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0" i="0" u="none" strike="noStrike" baseline="0" dirty="0">
                    <a:effectLst/>
                  </a:rPr>
                  <a:t>figure S5. </a:t>
                </a:r>
                <a:r>
                  <a:rPr lang="en-US" sz="1600" b="0" i="0" baseline="0" dirty="0">
                    <a:solidFill>
                      <a:schemeClr val="tx1"/>
                    </a:solidFill>
                    <a:effectLst/>
                  </a:rPr>
                  <a:t>HIV-1C nef 3'PPT variability amongst sequences from individuals on ART and not on ART, n = 2992( hypermutations removed)</a:t>
                </a:r>
                <a:endParaRPr lang="en-US" sz="1600" dirty="0"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600">
                    <a:solidFill>
                      <a:schemeClr val="tx1"/>
                    </a:solidFill>
                  </a:defRPr>
                </a:pPr>
                <a:endParaRPr lang="en-US" sz="16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2.3973857664749392E-2"/>
              <c:y val="0.860591391656968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6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2280000" spcFirstLastPara="1" vertOverflow="ellipsis" wrap="square" anchor="ctr" anchorCtr="0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1624800"/>
        <c:crosses val="autoZero"/>
        <c:auto val="1"/>
        <c:lblAlgn val="ctr"/>
        <c:lblOffset val="100"/>
        <c:tickMarkSkip val="1"/>
        <c:noMultiLvlLbl val="0"/>
      </c:catAx>
      <c:valAx>
        <c:axId val="671624800"/>
        <c:scaling>
          <c:orientation val="minMax"/>
          <c:max val="1"/>
        </c:scaling>
        <c:delete val="0"/>
        <c:axPos val="l"/>
        <c:majorGridlines>
          <c:spPr>
            <a:ln w="6350" cap="flat" cmpd="sng" algn="ctr">
              <a:solidFill>
                <a:schemeClr val="tx1">
                  <a:alpha val="31000"/>
                </a:schemeClr>
              </a:solidFill>
              <a:round/>
            </a:ln>
            <a:effectLst>
              <a:outerShdw dir="5400000" sx="1000" sy="1000" algn="ctr" rotWithShape="0">
                <a:schemeClr val="bg1"/>
              </a:outerShdw>
            </a:effectLst>
          </c:spPr>
        </c:majorGridlines>
        <c:numFmt formatCode="0.0%" sourceLinked="0"/>
        <c:majorTickMark val="out"/>
        <c:minorTickMark val="in"/>
        <c:tickLblPos val="nextTo"/>
        <c:spPr>
          <a:noFill/>
          <a:ln w="12700" cap="rnd" cmpd="sng">
            <a:solidFill>
              <a:schemeClr val="tx1">
                <a:alpha val="32000"/>
              </a:schemeClr>
            </a:solidFill>
          </a:ln>
          <a:effectLst>
            <a:glow>
              <a:schemeClr val="bg1">
                <a:alpha val="79000"/>
              </a:schemeClr>
            </a:glow>
            <a:outerShdw blurRad="25400" dist="50800" dir="5400000" algn="ctr" rotWithShape="0">
              <a:schemeClr val="bg1"/>
            </a:outerShdw>
          </a:effectLst>
        </c:spPr>
        <c:txPr>
          <a:bodyPr rot="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1618896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b="0" i="0" baseline="0">
                <a:solidFill>
                  <a:schemeClr val="tx1"/>
                </a:solidFill>
                <a:effectLst/>
              </a:rPr>
              <a:t>HIV-1 nef 3'PPT HxB2 nucleotide positions</a:t>
            </a:r>
            <a:endParaRPr lang="en-US" sz="1200"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>
                <a:solidFill>
                  <a:schemeClr val="tx1"/>
                </a:solidFill>
              </a:defRPr>
            </a:pPr>
            <a:endParaRPr lang="en-US" sz="120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2139255326753666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2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4938274254812548E-2"/>
          <c:y val="0.12638888888888888"/>
          <c:w val="0.93202468992478837"/>
          <c:h val="0.5904524506884045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BCPP_nef.3PPTregion_5duplicates_removed_kks_17March2021.xlsx]ART naive_hypermuts_remvd_n=762'!$LB$810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ART naive_hypermuts_remvd_n=762'!$LC$808:$LT$809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ART naive_hypermuts_remvd_n=762'!$LC$810:$LT$810</c:f>
              <c:numCache>
                <c:formatCode>0.00%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  <c:pt idx="4">
                  <c:v>0.99737532808398954</c:v>
                </c:pt>
                <c:pt idx="5">
                  <c:v>1</c:v>
                </c:pt>
                <c:pt idx="6">
                  <c:v>0</c:v>
                </c:pt>
                <c:pt idx="7">
                  <c:v>0.99868766404199472</c:v>
                </c:pt>
                <c:pt idx="8">
                  <c:v>0.99212598425196852</c:v>
                </c:pt>
                <c:pt idx="9">
                  <c:v>1</c:v>
                </c:pt>
                <c:pt idx="10">
                  <c:v>0.99737187910643887</c:v>
                </c:pt>
                <c:pt idx="11">
                  <c:v>9.1984231274638631E-3</c:v>
                </c:pt>
                <c:pt idx="12">
                  <c:v>2.6281208935611039E-3</c:v>
                </c:pt>
                <c:pt idx="13">
                  <c:v>1.3140604467805519E-3</c:v>
                </c:pt>
                <c:pt idx="14">
                  <c:v>6.5703022339027592E-3</c:v>
                </c:pt>
                <c:pt idx="15">
                  <c:v>1.3140604467805519E-3</c:v>
                </c:pt>
                <c:pt idx="16">
                  <c:v>0</c:v>
                </c:pt>
                <c:pt idx="1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E0-4935-A31E-D8E267E77791}"/>
            </c:ext>
          </c:extLst>
        </c:ser>
        <c:ser>
          <c:idx val="1"/>
          <c:order val="1"/>
          <c:tx>
            <c:strRef>
              <c:f>'[BCPP_nef.3PPTregion_5duplicates_removed_kks_17March2021.xlsx]ART naive_hypermuts_remvd_n=762'!$LB$811</c:f>
              <c:strCache>
                <c:ptCount val="1"/>
                <c:pt idx="0">
                  <c:v>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ART naive_hypermuts_remvd_n=762'!$LC$808:$LT$809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ART naive_hypermuts_remvd_n=762'!$LC$811:$LT$811</c:f>
              <c:numCache>
                <c:formatCode>0.00%</c:formatCode>
                <c:ptCount val="18"/>
                <c:pt idx="0">
                  <c:v>0.99868593955321949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.2493438320209973E-3</c:v>
                </c:pt>
                <c:pt idx="9">
                  <c:v>0</c:v>
                </c:pt>
                <c:pt idx="10">
                  <c:v>0</c:v>
                </c:pt>
                <c:pt idx="11">
                  <c:v>1.3140604467805519E-3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E0-4935-A31E-D8E267E77791}"/>
            </c:ext>
          </c:extLst>
        </c:ser>
        <c:ser>
          <c:idx val="2"/>
          <c:order val="2"/>
          <c:tx>
            <c:strRef>
              <c:f>'[BCPP_nef.3PPTregion_5duplicates_removed_kks_17March2021.xlsx]ART naive_hypermuts_remvd_n=762'!$LB$812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ART naive_hypermuts_remvd_n=762'!$LC$808:$LT$809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ART naive_hypermuts_remvd_n=762'!$LC$812:$LT$812</c:f>
              <c:numCache>
                <c:formatCode>0.00%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.6246719160104987E-3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.3140604467805519E-3</c:v>
                </c:pt>
                <c:pt idx="11">
                  <c:v>0.98817345597897499</c:v>
                </c:pt>
                <c:pt idx="12">
                  <c:v>0.99737187910643887</c:v>
                </c:pt>
                <c:pt idx="13">
                  <c:v>0.99868593955321949</c:v>
                </c:pt>
                <c:pt idx="14">
                  <c:v>0.99211563731931673</c:v>
                </c:pt>
                <c:pt idx="15">
                  <c:v>0.99868593955321949</c:v>
                </c:pt>
                <c:pt idx="16">
                  <c:v>1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5E0-4935-A31E-D8E267E77791}"/>
            </c:ext>
          </c:extLst>
        </c:ser>
        <c:ser>
          <c:idx val="3"/>
          <c:order val="3"/>
          <c:tx>
            <c:strRef>
              <c:f>'[BCPP_nef.3PPTregion_5duplicates_removed_kks_17March2021.xlsx]ART naive_hypermuts_remvd_n=762'!$LB$813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ART naive_hypermuts_remvd_n=762'!$LC$808:$LT$809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ART naive_hypermuts_remvd_n=762'!$LC$813:$LT$813</c:f>
              <c:numCache>
                <c:formatCode>0.00%</c:formatCode>
                <c:ptCount val="18"/>
                <c:pt idx="0">
                  <c:v>1.3140604467805519E-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3123359580052493E-3</c:v>
                </c:pt>
                <c:pt idx="8">
                  <c:v>2.6246719160104987E-3</c:v>
                </c:pt>
                <c:pt idx="9">
                  <c:v>0</c:v>
                </c:pt>
                <c:pt idx="10">
                  <c:v>1.3140604467805519E-3</c:v>
                </c:pt>
                <c:pt idx="11">
                  <c:v>1.3140604467805519E-3</c:v>
                </c:pt>
                <c:pt idx="12">
                  <c:v>0</c:v>
                </c:pt>
                <c:pt idx="13">
                  <c:v>0</c:v>
                </c:pt>
                <c:pt idx="14">
                  <c:v>1.3140604467805519E-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5E0-4935-A31E-D8E267E777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02590056"/>
        <c:axId val="1102591040"/>
      </c:barChart>
      <c:catAx>
        <c:axId val="11025900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0" i="0" u="none" strike="noStrike" baseline="0" dirty="0">
                    <a:effectLst/>
                  </a:rPr>
                  <a:t>figure S6. </a:t>
                </a:r>
                <a:r>
                  <a:rPr lang="en-US" sz="1100" b="0" i="0" baseline="0" dirty="0">
                    <a:solidFill>
                      <a:schemeClr val="tx1"/>
                    </a:solidFill>
                    <a:effectLst/>
                  </a:rPr>
                  <a:t>HIV-1C </a:t>
                </a:r>
                <a:r>
                  <a:rPr lang="en-US" sz="1100" b="0" i="1" baseline="0" dirty="0">
                    <a:solidFill>
                      <a:schemeClr val="tx1"/>
                    </a:solidFill>
                    <a:effectLst/>
                  </a:rPr>
                  <a:t>nef </a:t>
                </a:r>
                <a:r>
                  <a:rPr lang="en-US" sz="1100" b="0" i="0" baseline="0" dirty="0">
                    <a:solidFill>
                      <a:schemeClr val="tx1"/>
                    </a:solidFill>
                    <a:effectLst/>
                  </a:rPr>
                  <a:t>3'PPT variability amongst ART naive individuals, n = 762 (hypermutations removed) </a:t>
                </a:r>
                <a:endParaRPr lang="en-US" sz="1100" dirty="0"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>
                    <a:solidFill>
                      <a:schemeClr val="tx1"/>
                    </a:solidFill>
                  </a:defRPr>
                </a:pPr>
                <a:endParaRPr lang="en-US" sz="11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2.7642995378898069E-2"/>
              <c:y val="0.931551083217548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2591040"/>
        <c:crosses val="autoZero"/>
        <c:auto val="1"/>
        <c:lblAlgn val="ctr"/>
        <c:lblOffset val="100"/>
        <c:noMultiLvlLbl val="0"/>
      </c:catAx>
      <c:valAx>
        <c:axId val="1102591040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2590056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baseline="0">
                <a:solidFill>
                  <a:schemeClr val="tx1"/>
                </a:solidFill>
                <a:effectLst/>
              </a:rPr>
              <a:t>HIV-1 nef 3'PPT HxB2 nucleotide positions</a:t>
            </a:r>
            <a:endParaRPr lang="en-US" sz="1400">
              <a:solidFill>
                <a:schemeClr val="tx1"/>
              </a:solidFill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1987475750313821E-2"/>
          <c:y val="0.13048376525703509"/>
          <c:w val="0.94804875613374417"/>
          <c:h val="0.570957158209445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BCPP_nef.3PPTregion_5duplicates_removed_kks_17March2021.xlsx]on ART_VL&lt;400_hymermuts_n=2,074'!$LB$2122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_VL&lt;400_hymermuts_n=2,074'!$LC$2120:$LT$2121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_VL&lt;400_hymermuts_n=2,074'!$LC$2122:$LT$2122</c:f>
              <c:numCache>
                <c:formatCode>0.00%</c:formatCode>
                <c:ptCount val="18"/>
                <c:pt idx="0">
                  <c:v>1.4478764478764478E-3</c:v>
                </c:pt>
                <c:pt idx="1">
                  <c:v>0</c:v>
                </c:pt>
                <c:pt idx="2">
                  <c:v>0.99903474903474898</c:v>
                </c:pt>
                <c:pt idx="3">
                  <c:v>0.99951737451737455</c:v>
                </c:pt>
                <c:pt idx="4">
                  <c:v>0.99806949806949807</c:v>
                </c:pt>
                <c:pt idx="5">
                  <c:v>0.99855212355212353</c:v>
                </c:pt>
                <c:pt idx="6">
                  <c:v>3.376748673420164E-3</c:v>
                </c:pt>
                <c:pt idx="7">
                  <c:v>0.99855212355212353</c:v>
                </c:pt>
                <c:pt idx="8">
                  <c:v>0.99662325132657981</c:v>
                </c:pt>
                <c:pt idx="9">
                  <c:v>0.99807042932947421</c:v>
                </c:pt>
                <c:pt idx="10">
                  <c:v>0.9985528219971056</c:v>
                </c:pt>
                <c:pt idx="11">
                  <c:v>8.2046332046332038E-3</c:v>
                </c:pt>
                <c:pt idx="12">
                  <c:v>3.3783783783783786E-3</c:v>
                </c:pt>
                <c:pt idx="13">
                  <c:v>2.4131274131274131E-3</c:v>
                </c:pt>
                <c:pt idx="14">
                  <c:v>1.2065637065637066E-2</c:v>
                </c:pt>
                <c:pt idx="15">
                  <c:v>2.8943560057887118E-3</c:v>
                </c:pt>
                <c:pt idx="16">
                  <c:v>4.8239266763145202E-4</c:v>
                </c:pt>
                <c:pt idx="17">
                  <c:v>0.99855282199710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55-4500-A5E1-AE0FF04183E4}"/>
            </c:ext>
          </c:extLst>
        </c:ser>
        <c:ser>
          <c:idx val="1"/>
          <c:order val="1"/>
          <c:tx>
            <c:strRef>
              <c:f>'[BCPP_nef.3PPTregion_5duplicates_removed_kks_17March2021.xlsx]on ART_VL&lt;400_hymermuts_n=2,074'!$LB$2123</c:f>
              <c:strCache>
                <c:ptCount val="1"/>
                <c:pt idx="0">
                  <c:v>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_VL&lt;400_hymermuts_n=2,074'!$LC$2120:$LT$2121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_VL&lt;400_hymermuts_n=2,074'!$LC$2123:$LT$2123</c:f>
              <c:numCache>
                <c:formatCode>0.00%</c:formatCode>
                <c:ptCount val="18"/>
                <c:pt idx="0">
                  <c:v>0.99758687258687262</c:v>
                </c:pt>
                <c:pt idx="1">
                  <c:v>0.9995173745173745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9295706705258081E-3</c:v>
                </c:pt>
                <c:pt idx="9">
                  <c:v>4.8239266763145202E-4</c:v>
                </c:pt>
                <c:pt idx="10">
                  <c:v>4.8239266763145202E-4</c:v>
                </c:pt>
                <c:pt idx="11">
                  <c:v>2.4131274131274131E-3</c:v>
                </c:pt>
                <c:pt idx="12">
                  <c:v>0</c:v>
                </c:pt>
                <c:pt idx="13">
                  <c:v>0</c:v>
                </c:pt>
                <c:pt idx="14">
                  <c:v>4.8262548262548264E-4</c:v>
                </c:pt>
                <c:pt idx="15">
                  <c:v>0</c:v>
                </c:pt>
                <c:pt idx="16">
                  <c:v>0</c:v>
                </c:pt>
                <c:pt idx="17">
                  <c:v>4.823926676314520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C55-4500-A5E1-AE0FF04183E4}"/>
            </c:ext>
          </c:extLst>
        </c:ser>
        <c:ser>
          <c:idx val="2"/>
          <c:order val="2"/>
          <c:tx>
            <c:strRef>
              <c:f>'[BCPP_nef.3PPTregion_5duplicates_removed_kks_17March2021.xlsx]on ART_VL&lt;400_hymermuts_n=2,074'!$LB$2124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_VL&lt;400_hymermuts_n=2,074'!$LC$2120:$LT$2121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_VL&lt;400_hymermuts_n=2,074'!$LC$2124:$LT$2124</c:f>
              <c:numCache>
                <c:formatCode>0.00%</c:formatCode>
                <c:ptCount val="18"/>
                <c:pt idx="0">
                  <c:v>4.8262548262548264E-4</c:v>
                </c:pt>
                <c:pt idx="1">
                  <c:v>4.8262548262548264E-4</c:v>
                </c:pt>
                <c:pt idx="2">
                  <c:v>4.8262548262548264E-4</c:v>
                </c:pt>
                <c:pt idx="3">
                  <c:v>4.8262548262548264E-4</c:v>
                </c:pt>
                <c:pt idx="4">
                  <c:v>1.4478764478764478E-3</c:v>
                </c:pt>
                <c:pt idx="5">
                  <c:v>9.6525096525096527E-4</c:v>
                </c:pt>
                <c:pt idx="6">
                  <c:v>0.99614085865894841</c:v>
                </c:pt>
                <c:pt idx="7">
                  <c:v>4.8262548262548264E-4</c:v>
                </c:pt>
                <c:pt idx="8">
                  <c:v>0</c:v>
                </c:pt>
                <c:pt idx="9">
                  <c:v>9.6478533526290404E-4</c:v>
                </c:pt>
                <c:pt idx="10">
                  <c:v>9.6478533526290404E-4</c:v>
                </c:pt>
                <c:pt idx="11">
                  <c:v>0.98938223938223935</c:v>
                </c:pt>
                <c:pt idx="12">
                  <c:v>0.99613899613899615</c:v>
                </c:pt>
                <c:pt idx="13">
                  <c:v>0.99710424710424705</c:v>
                </c:pt>
                <c:pt idx="14">
                  <c:v>0.98745173745173742</c:v>
                </c:pt>
                <c:pt idx="15">
                  <c:v>0.99710564399421131</c:v>
                </c:pt>
                <c:pt idx="16">
                  <c:v>0.9995176073323685</c:v>
                </c:pt>
                <c:pt idx="17">
                  <c:v>4.823926676314520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C55-4500-A5E1-AE0FF04183E4}"/>
            </c:ext>
          </c:extLst>
        </c:ser>
        <c:ser>
          <c:idx val="3"/>
          <c:order val="3"/>
          <c:tx>
            <c:strRef>
              <c:f>'[BCPP_nef.3PPTregion_5duplicates_removed_kks_17March2021.xlsx]on ART_VL&lt;400_hymermuts_n=2,074'!$LB$2125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_VL&lt;400_hymermuts_n=2,074'!$LC$2120:$LT$2121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_VL&lt;400_hymermuts_n=2,074'!$LC$2125:$LT$2125</c:f>
              <c:numCache>
                <c:formatCode>0.00%</c:formatCode>
                <c:ptCount val="18"/>
                <c:pt idx="0">
                  <c:v>4.8262548262548264E-4</c:v>
                </c:pt>
                <c:pt idx="1">
                  <c:v>0</c:v>
                </c:pt>
                <c:pt idx="2">
                  <c:v>4.8262548262548264E-4</c:v>
                </c:pt>
                <c:pt idx="3">
                  <c:v>0</c:v>
                </c:pt>
                <c:pt idx="4">
                  <c:v>4.8262548262548264E-4</c:v>
                </c:pt>
                <c:pt idx="5">
                  <c:v>4.8262548262548264E-4</c:v>
                </c:pt>
                <c:pt idx="6">
                  <c:v>4.8239266763145202E-4</c:v>
                </c:pt>
                <c:pt idx="7">
                  <c:v>9.6525096525096527E-4</c:v>
                </c:pt>
                <c:pt idx="8">
                  <c:v>1.4471780028943559E-3</c:v>
                </c:pt>
                <c:pt idx="9">
                  <c:v>4.8239266763145202E-4</c:v>
                </c:pt>
                <c:pt idx="10">
                  <c:v>0</c:v>
                </c:pt>
                <c:pt idx="11">
                  <c:v>0</c:v>
                </c:pt>
                <c:pt idx="12">
                  <c:v>4.8262548262548264E-4</c:v>
                </c:pt>
                <c:pt idx="13">
                  <c:v>4.8262548262548264E-4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4.823926676314520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C55-4500-A5E1-AE0FF04183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20639888"/>
        <c:axId val="1120636936"/>
      </c:barChart>
      <c:catAx>
        <c:axId val="11206398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u="none" strike="noStrike" baseline="0" dirty="0">
                    <a:effectLst/>
                  </a:rPr>
                  <a:t>figure S7. </a:t>
                </a:r>
                <a:r>
                  <a:rPr lang="en-US" sz="1200" b="0" i="0" baseline="0" dirty="0">
                    <a:solidFill>
                      <a:schemeClr val="tx1"/>
                    </a:solidFill>
                    <a:effectLst/>
                  </a:rPr>
                  <a:t>HIV-1C </a:t>
                </a:r>
                <a:r>
                  <a:rPr lang="en-US" sz="1200" b="0" i="1" baseline="0" dirty="0">
                    <a:solidFill>
                      <a:schemeClr val="tx1"/>
                    </a:solidFill>
                    <a:effectLst/>
                  </a:rPr>
                  <a:t>nef</a:t>
                </a:r>
                <a:r>
                  <a:rPr lang="en-US" sz="1200" b="0" i="0" baseline="0" dirty="0">
                    <a:solidFill>
                      <a:schemeClr val="tx1"/>
                    </a:solidFill>
                    <a:effectLst/>
                  </a:rPr>
                  <a:t> 3'PPT variability amongst individuals on ART with VL ≤ 400copies/mL , n = 2074 (</a:t>
                </a:r>
                <a:r>
                  <a:rPr lang="en-US" sz="1200" b="0" i="0" u="none" strike="noStrike" baseline="0" dirty="0">
                    <a:effectLst/>
                  </a:rPr>
                  <a:t>hypermutations removed)</a:t>
                </a:r>
                <a:endParaRPr lang="en-US" sz="1200" dirty="0"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>
                    <a:solidFill>
                      <a:schemeClr val="tx1"/>
                    </a:solidFill>
                  </a:defRPr>
                </a:pPr>
                <a:endParaRPr lang="en-US" sz="12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2.6075259614287343E-2"/>
              <c:y val="0.904224162746548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0636936"/>
        <c:crosses val="autoZero"/>
        <c:auto val="1"/>
        <c:lblAlgn val="ctr"/>
        <c:lblOffset val="100"/>
        <c:noMultiLvlLbl val="0"/>
      </c:catAx>
      <c:valAx>
        <c:axId val="1120636936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0639888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6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600" b="0" i="0" baseline="0">
                <a:solidFill>
                  <a:schemeClr val="tx1"/>
                </a:solidFill>
                <a:effectLst/>
              </a:rPr>
              <a:t>HIV-1 nef 3'PPT HxB2 nucleotide positions</a:t>
            </a:r>
            <a:endParaRPr lang="en-US" sz="1600">
              <a:solidFill>
                <a:schemeClr val="tx1"/>
              </a:solidFill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6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7994757393080845E-2"/>
          <c:y val="0.12869233843379815"/>
          <c:w val="0.94211019036678056"/>
          <c:h val="0.589334847998054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BCPP_nef.3PPTregion_5duplicates_removed_kks_17March2021.xlsx]on ART VL&gt;400 n=119'!$LB$167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 VL&gt;400 n=119'!$LC$165:$LT$16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 VL&gt;400 n=119'!$LC$167:$LT$167</c:f>
              <c:numCache>
                <c:formatCode>0.00%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0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0.99159663865546221</c:v>
                </c:pt>
                <c:pt idx="11">
                  <c:v>8.4033613445378148E-3</c:v>
                </c:pt>
                <c:pt idx="12">
                  <c:v>0</c:v>
                </c:pt>
                <c:pt idx="13">
                  <c:v>0</c:v>
                </c:pt>
                <c:pt idx="14">
                  <c:v>8.3333333333333332E-3</c:v>
                </c:pt>
                <c:pt idx="15">
                  <c:v>0</c:v>
                </c:pt>
                <c:pt idx="16">
                  <c:v>0</c:v>
                </c:pt>
                <c:pt idx="1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9A-4F3E-9464-76F25D58C3DE}"/>
            </c:ext>
          </c:extLst>
        </c:ser>
        <c:ser>
          <c:idx val="1"/>
          <c:order val="1"/>
          <c:tx>
            <c:strRef>
              <c:f>'[BCPP_nef.3PPTregion_5duplicates_removed_kks_17March2021.xlsx]on ART VL&gt;400 n=119'!$LB$168</c:f>
              <c:strCache>
                <c:ptCount val="1"/>
                <c:pt idx="0">
                  <c:v>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 VL&gt;400 n=119'!$LC$165:$LT$16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 VL&gt;400 n=119'!$LC$168:$LT$168</c:f>
              <c:numCache>
                <c:formatCode>0.00%</c:formatCode>
                <c:ptCount val="18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8.3333333333333332E-3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59A-4F3E-9464-76F25D58C3DE}"/>
            </c:ext>
          </c:extLst>
        </c:ser>
        <c:ser>
          <c:idx val="2"/>
          <c:order val="2"/>
          <c:tx>
            <c:strRef>
              <c:f>'[BCPP_nef.3PPTregion_5duplicates_removed_kks_17March2021.xlsx]on ART VL&gt;400 n=119'!$LB$169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 VL&gt;400 n=119'!$LC$165:$LT$16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 VL&gt;400 n=119'!$LC$169:$LT$169</c:f>
              <c:numCache>
                <c:formatCode>0.00%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8.4033613445378148E-3</c:v>
                </c:pt>
                <c:pt idx="11">
                  <c:v>0.99159663865546221</c:v>
                </c:pt>
                <c:pt idx="12">
                  <c:v>1</c:v>
                </c:pt>
                <c:pt idx="13">
                  <c:v>1</c:v>
                </c:pt>
                <c:pt idx="14">
                  <c:v>0.9916666666666667</c:v>
                </c:pt>
                <c:pt idx="15">
                  <c:v>1</c:v>
                </c:pt>
                <c:pt idx="16">
                  <c:v>0.9916666666666667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59A-4F3E-9464-76F25D58C3DE}"/>
            </c:ext>
          </c:extLst>
        </c:ser>
        <c:ser>
          <c:idx val="3"/>
          <c:order val="3"/>
          <c:tx>
            <c:strRef>
              <c:f>'[BCPP_nef.3PPTregion_5duplicates_removed_kks_17March2021.xlsx]on ART VL&gt;400 n=119'!$LB$170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BCPP_nef.3PPTregion_5duplicates_removed_kks_17March2021.xlsx]on ART VL&gt;400 n=119'!$LC$165:$LT$166</c:f>
              <c:strCache>
                <c:ptCount val="18"/>
                <c:pt idx="0">
                  <c:v>T 9067</c:v>
                </c:pt>
                <c:pt idx="1">
                  <c:v>T 9068</c:v>
                </c:pt>
                <c:pt idx="2">
                  <c:v>A 9069</c:v>
                </c:pt>
                <c:pt idx="3">
                  <c:v>A 9070</c:v>
                </c:pt>
                <c:pt idx="4">
                  <c:v>A 9071</c:v>
                </c:pt>
                <c:pt idx="5">
                  <c:v>A 9072</c:v>
                </c:pt>
                <c:pt idx="6">
                  <c:v>G 9073</c:v>
                </c:pt>
                <c:pt idx="7">
                  <c:v>A 9074</c:v>
                </c:pt>
                <c:pt idx="8">
                  <c:v>A 9075</c:v>
                </c:pt>
                <c:pt idx="9">
                  <c:v>A 9076</c:v>
                </c:pt>
                <c:pt idx="10">
                  <c:v>A 9077</c:v>
                </c:pt>
                <c:pt idx="11">
                  <c:v>G 9078</c:v>
                </c:pt>
                <c:pt idx="12">
                  <c:v>G 9079</c:v>
                </c:pt>
                <c:pt idx="13">
                  <c:v>G 9080</c:v>
                </c:pt>
                <c:pt idx="14">
                  <c:v>G 9081</c:v>
                </c:pt>
                <c:pt idx="15">
                  <c:v>G 9082</c:v>
                </c:pt>
                <c:pt idx="16">
                  <c:v>G 9083</c:v>
                </c:pt>
                <c:pt idx="17">
                  <c:v>G 9084</c:v>
                </c:pt>
              </c:strCache>
            </c:strRef>
          </c:cat>
          <c:val>
            <c:numRef>
              <c:f>'[BCPP_nef.3PPTregion_5duplicates_removed_kks_17March2021.xlsx]on ART VL&gt;400 n=119'!$LC$170:$LT$170</c:f>
              <c:numCache>
                <c:formatCode>0.00%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59A-4F3E-9464-76F25D58C3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7391328"/>
        <c:axId val="627386408"/>
      </c:barChart>
      <c:catAx>
        <c:axId val="6273913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u="none" strike="noStrike" baseline="0" dirty="0">
                    <a:effectLst/>
                  </a:rPr>
                  <a:t>figure S8. </a:t>
                </a:r>
                <a:r>
                  <a:rPr lang="en-US" sz="1200" b="0" i="0" baseline="0" dirty="0">
                    <a:solidFill>
                      <a:schemeClr val="tx1"/>
                    </a:solidFill>
                    <a:effectLst/>
                  </a:rPr>
                  <a:t>HIV-1C </a:t>
                </a:r>
                <a:r>
                  <a:rPr lang="en-US" sz="1200" b="0" i="1" baseline="0" dirty="0">
                    <a:solidFill>
                      <a:schemeClr val="tx1"/>
                    </a:solidFill>
                    <a:effectLst/>
                  </a:rPr>
                  <a:t>nef</a:t>
                </a:r>
                <a:r>
                  <a:rPr lang="en-US" sz="1200" b="0" i="0" baseline="0" dirty="0">
                    <a:solidFill>
                      <a:schemeClr val="tx1"/>
                    </a:solidFill>
                    <a:effectLst/>
                  </a:rPr>
                  <a:t> 3'PPT variability amongst individuals on ART with VL &gt; 400copies/mL ,n = 119 ( hypermutation removed)</a:t>
                </a:r>
                <a:endParaRPr lang="en-US" sz="1200" dirty="0"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>
                    <a:solidFill>
                      <a:schemeClr val="tx1"/>
                    </a:solidFill>
                  </a:defRPr>
                </a:pPr>
                <a:endParaRPr lang="en-US" sz="12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784052542786508E-2"/>
              <c:y val="0.913942568253543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7386408"/>
        <c:crosses val="autoZero"/>
        <c:auto val="1"/>
        <c:lblAlgn val="ctr"/>
        <c:lblOffset val="100"/>
        <c:noMultiLvlLbl val="0"/>
      </c:catAx>
      <c:valAx>
        <c:axId val="62738640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7391328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3924</cdr:x>
      <cdr:y>0.10463</cdr:y>
    </cdr:from>
    <cdr:to>
      <cdr:x>0.89055</cdr:x>
      <cdr:y>0.18648</cdr:y>
    </cdr:to>
    <cdr:sp macro="" textlink="">
      <cdr:nvSpPr>
        <cdr:cNvPr id="3" name="Left Brace 2">
          <a:extLst xmlns:a="http://schemas.openxmlformats.org/drawingml/2006/main">
            <a:ext uri="{FF2B5EF4-FFF2-40B4-BE49-F238E27FC236}">
              <a16:creationId xmlns:a16="http://schemas.microsoft.com/office/drawing/2014/main" id="{4F49F66D-F3D1-4C7C-A4E4-480A0D36B39B}"/>
            </a:ext>
          </a:extLst>
        </cdr:cNvPr>
        <cdr:cNvSpPr/>
      </cdr:nvSpPr>
      <cdr:spPr>
        <a:xfrm xmlns:a="http://schemas.openxmlformats.org/drawingml/2006/main" rot="5400000">
          <a:off x="8153043" y="-5328017"/>
          <a:ext cx="438802" cy="12216717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>
              <a:alpha val="90000"/>
            </a:schemeClr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4136</cdr:x>
      <cdr:y>0.10205</cdr:y>
    </cdr:from>
    <cdr:to>
      <cdr:x>0.89267</cdr:x>
      <cdr:y>0.1839</cdr:y>
    </cdr:to>
    <cdr:sp macro="" textlink="">
      <cdr:nvSpPr>
        <cdr:cNvPr id="3" name="Left Brace 2">
          <a:extLst xmlns:a="http://schemas.openxmlformats.org/drawingml/2006/main">
            <a:ext uri="{FF2B5EF4-FFF2-40B4-BE49-F238E27FC236}">
              <a16:creationId xmlns:a16="http://schemas.microsoft.com/office/drawing/2014/main" id="{4F49F66D-F3D1-4C7C-A4E4-480A0D36B39B}"/>
            </a:ext>
          </a:extLst>
        </cdr:cNvPr>
        <cdr:cNvSpPr/>
      </cdr:nvSpPr>
      <cdr:spPr>
        <a:xfrm xmlns:a="http://schemas.openxmlformats.org/drawingml/2006/main" rot="5400000">
          <a:off x="7571053" y="-5037122"/>
          <a:ext cx="335299" cy="11245614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>
              <a:alpha val="90000"/>
            </a:schemeClr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3924</cdr:x>
      <cdr:y>0.10463</cdr:y>
    </cdr:from>
    <cdr:to>
      <cdr:x>0.89055</cdr:x>
      <cdr:y>0.18648</cdr:y>
    </cdr:to>
    <cdr:sp macro="" textlink="">
      <cdr:nvSpPr>
        <cdr:cNvPr id="3" name="Left Brace 2">
          <a:extLst xmlns:a="http://schemas.openxmlformats.org/drawingml/2006/main">
            <a:ext uri="{FF2B5EF4-FFF2-40B4-BE49-F238E27FC236}">
              <a16:creationId xmlns:a16="http://schemas.microsoft.com/office/drawing/2014/main" id="{4F49F66D-F3D1-4C7C-A4E4-480A0D36B39B}"/>
            </a:ext>
          </a:extLst>
        </cdr:cNvPr>
        <cdr:cNvSpPr/>
      </cdr:nvSpPr>
      <cdr:spPr>
        <a:xfrm xmlns:a="http://schemas.openxmlformats.org/drawingml/2006/main" rot="5400000">
          <a:off x="8153043" y="-5328017"/>
          <a:ext cx="438802" cy="12216717"/>
        </a:xfrm>
        <a:prstGeom xmlns:a="http://schemas.openxmlformats.org/drawingml/2006/main" prst="leftBrace">
          <a:avLst/>
        </a:prstGeom>
        <a:ln xmlns:a="http://schemas.openxmlformats.org/drawingml/2006/main">
          <a:solidFill>
            <a:schemeClr val="tx1">
              <a:alpha val="90000"/>
            </a:schemeClr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CB2AB0-E4D0-4CF9-8CFA-FA0F4F8EF4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BC18A5-5862-4133-959C-81379585A5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124568-F547-4D3B-A0A9-B97A47930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DFF1CB-F909-4D7C-ADAB-CE3B44FDF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AD768-B8F7-4DDA-90EB-52E3848CE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0452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D7E9CC-369A-4E1D-8371-61368C3DFA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A4B434-8638-44F2-9F95-0F62264031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E45A5E-61BA-4E0B-A481-514A42CF5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D67253-29FB-4790-9CBD-496A3FFEF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8E8EF0-5A6A-487D-AC3F-DE7CAD11C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4352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454797-BAD2-453B-BC4C-032BF83672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3200CF-6504-4E45-8A24-B52AF4CD9A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994EC7-D049-42D5-9534-6906146EA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C29CC4-6B85-4B4F-971A-25D910106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9FE701-CB0F-4F14-A8EA-F3E9C259A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0417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FFACA5-DC0F-4B65-BA64-04FEC177A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64BECA-CC85-4E3B-B222-E661B431ED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185EA-DAD8-464E-B6D0-C310877EB8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6014AD-B47E-4268-9997-4A2CC110D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510634-AA20-4965-8DC9-5F73894E6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2522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08B6DF-344C-4DA4-8583-E5DD55FFA2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411CA9-D8FF-4B92-85AB-526ADB6A22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8A5951-3DD8-4623-A476-7ADD82348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463EA0-3471-4EE9-87EB-1DF8D88BC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DEAD8F-EC86-405C-B4FE-E548FC6A5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6436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CC1C2-C90B-41E5-90F3-FA13B5E4E8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48E33E-C771-4F95-B774-D574A0B173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E76B0D-250F-461E-81E6-27AF1F1170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06C86B-E782-48F9-9C9D-0289315DB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A2011B-F93E-4196-99E4-3D01304872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84F49A-D780-47BE-BF80-4B598FCCF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2329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1B762-3B13-4D9F-9C08-928EBAE631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B47778-BA97-4591-BA5C-29EB7A646E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6EF7E1-03E0-43B3-A0DC-91C2960E8F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6C1922D-F650-4B61-B182-E04A192E36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0E360C5-6921-49FF-9E9B-6A124C7D3F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D554DC-740E-40B0-999D-3DAF6007F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A3063B7-F203-40D7-A752-577657841A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908FCC8-189D-4C34-BC5F-7F7EA4876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0078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4C9AD2-5D0E-40F5-8FED-D48C368BC4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E0A5E7-9D0B-4D59-AE64-68F30CD64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73F0D1-862E-4F74-8943-12346F5C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5C58376-185A-4340-9BBC-578C2F11B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7084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C90B763-1277-4130-B833-D269E622A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B189C0-6D71-4C27-9816-EA7A96557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B98DFE-D794-47E4-81BC-6CF3CF4F6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3053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02C703-ABEA-4214-8704-9C8CBFD0DC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6E319C-E2EF-4E52-9750-A05740D55D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1AE798-CF82-47D8-B2D3-8FB1E1648A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CBF1C5-A748-413C-8F03-EADCF48969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6D8906-3F45-4B0D-B475-D09CC52AC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29EF45-98BB-42F6-8036-0A9C67D89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7992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8F5932-E281-46C2-B79F-33298E76A4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37A4581-24A0-4C04-A6C4-F6D03F9887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9411E8-C112-4FB9-977B-F45EA25E7E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A48B64-69FC-474B-9821-7E8809CC1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6DDC7A-095D-4BEF-8754-B9A6ACFB1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3ED17C-A345-4AC2-9E04-BAD23700B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8539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C7411C-B2DF-4E78-80F6-C1A7C7B226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7DB350-A71A-48EE-97B7-CF91965EBF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ECE0A5-5619-46AC-962D-74A548F6A8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7D83C8-433C-4FD7-AA63-E328AE919081}" type="datetimeFigureOut">
              <a:rPr lang="en-GB" smtClean="0"/>
              <a:t>13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567248-A0DF-4242-BA66-B36BA45CA0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D8C20E-0A3C-44CF-BAF0-95D239BCA4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425826-C57B-4AC9-A038-BB29CA8B98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8535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E1A0E81-B572-4EA7-8A55-5DA617D01A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3554200"/>
              </p:ext>
            </p:extLst>
          </p:nvPr>
        </p:nvGraphicFramePr>
        <p:xfrm>
          <a:off x="2828259" y="315060"/>
          <a:ext cx="9173844" cy="4504713"/>
        </p:xfrm>
        <a:graphic>
          <a:graphicData uri="http://schemas.openxmlformats.org/drawingml/2006/table">
            <a:tbl>
              <a:tblPr/>
              <a:tblGrid>
                <a:gridCol w="509658">
                  <a:extLst>
                    <a:ext uri="{9D8B030D-6E8A-4147-A177-3AD203B41FA5}">
                      <a16:colId xmlns:a16="http://schemas.microsoft.com/office/drawing/2014/main" val="1552925744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4128635452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795936122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962430974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53029192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1604817030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3504447133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921931506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3784050875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1412310581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4023489055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2363058085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837922615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4068533920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1377750816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2102165643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4254791590"/>
                    </a:ext>
                  </a:extLst>
                </a:gridCol>
                <a:gridCol w="509658">
                  <a:extLst>
                    <a:ext uri="{9D8B030D-6E8A-4147-A177-3AD203B41FA5}">
                      <a16:colId xmlns:a16="http://schemas.microsoft.com/office/drawing/2014/main" val="3012126789"/>
                    </a:ext>
                  </a:extLst>
                </a:gridCol>
              </a:tblGrid>
              <a:tr h="314944">
                <a:tc>
                  <a:txBody>
                    <a:bodyPr/>
                    <a:lstStyle/>
                    <a:p>
                      <a:pPr algn="l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15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3’PPT of HIV-1 </a:t>
                      </a:r>
                      <a:r>
                        <a:rPr lang="en-US" sz="1400" b="1" i="1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nef</a:t>
                      </a:r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 gene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3609005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67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68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69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70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71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72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73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74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75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76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77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78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79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80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81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82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9083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84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7223658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1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2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3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4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5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6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7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8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9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0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1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2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3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4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5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6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7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8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2843930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9584277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6833948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4885195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7524316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2256084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7265603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3799307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188586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1755122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6520174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3622883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5413849"/>
                  </a:ext>
                </a:extLst>
              </a:tr>
              <a:tr h="2645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1905978"/>
                  </a:ext>
                </a:extLst>
              </a:tr>
              <a:tr h="186352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ucine, Leu, L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sine, Lys, K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tamic acid, Glu, E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sine, Lys, K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ine, Gly, 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ine, Gly, G</a:t>
                      </a:r>
                    </a:p>
                  </a:txBody>
                  <a:tcPr marL="8114" marR="8114" marT="81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14" marR="8114" marT="811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3329983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6E8ED999-BBA7-40AC-A18C-7013B23183C2}"/>
              </a:ext>
            </a:extLst>
          </p:cNvPr>
          <p:cNvSpPr txBox="1"/>
          <p:nvPr/>
        </p:nvSpPr>
        <p:spPr>
          <a:xfrm>
            <a:off x="94205" y="5471307"/>
            <a:ext cx="117696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ZA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</a:t>
            </a:r>
            <a:r>
              <a:rPr lang="en-ZA" sz="1200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1</a:t>
            </a:r>
            <a:r>
              <a:rPr lang="en-ZA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V-1C nef 3'PPT variability amongst 12 therapy experienced individuals experiencing VF while on DTG/RAL ART. We included the two proximal and last distal nct positions to the 3’PPT to complete aminoacid picture of the region; 3’polypurine tract, 3’PPT; </a:t>
            </a:r>
            <a:r>
              <a:rPr lang="en-GB" sz="1200" i="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ct, nucleotide; VL, viral load; seqs., sequences; VF, virological failure; DTG, dolutegravir; RAL, raltegravir; cART, combination antiretroviral therapy</a:t>
            </a:r>
            <a:r>
              <a:rPr lang="en-US" sz="12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dapted from figure 2a of Malet I et al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[7]</a:t>
            </a:r>
            <a:endParaRPr lang="en-US" sz="1200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E97586E-3556-47B9-AA51-6AA490EAF7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1880112"/>
              </p:ext>
            </p:extLst>
          </p:nvPr>
        </p:nvGraphicFramePr>
        <p:xfrm>
          <a:off x="94205" y="625642"/>
          <a:ext cx="2705100" cy="3994485"/>
        </p:xfrm>
        <a:graphic>
          <a:graphicData uri="http://schemas.openxmlformats.org/drawingml/2006/table">
            <a:tbl>
              <a:tblPr/>
              <a:tblGrid>
                <a:gridCol w="2705100">
                  <a:extLst>
                    <a:ext uri="{9D8B030D-6E8A-4147-A177-3AD203B41FA5}">
                      <a16:colId xmlns:a16="http://schemas.microsoft.com/office/drawing/2014/main" val="1237032442"/>
                    </a:ext>
                  </a:extLst>
                </a:gridCol>
              </a:tblGrid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XB2 nct nef number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4814283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f nct position numberi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823574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.FR.83.HXB2_LAI_IIIB_BRU.K03455_NE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9935067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01-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4722627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02-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3796724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04-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2240287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05-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497383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12-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0421066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13-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6655682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15-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553504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17-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5748316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18-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0507034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21-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9116796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026-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6600469"/>
                  </a:ext>
                </a:extLst>
              </a:tr>
              <a:tr h="266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9-0119-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34503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52853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855083F-3FD0-4B98-B494-E39ED52AAC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5108024"/>
              </p:ext>
            </p:extLst>
          </p:nvPr>
        </p:nvGraphicFramePr>
        <p:xfrm>
          <a:off x="276447" y="478466"/>
          <a:ext cx="11663916" cy="54332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553203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ECC4AC8-D79F-4E22-AFBE-60A7AC8882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5964117"/>
              </p:ext>
            </p:extLst>
          </p:nvPr>
        </p:nvGraphicFramePr>
        <p:xfrm>
          <a:off x="531628" y="542260"/>
          <a:ext cx="11121655" cy="59967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7582704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86361DD-6CD0-434F-93DF-609A6946C3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8900448"/>
              </p:ext>
            </p:extLst>
          </p:nvPr>
        </p:nvGraphicFramePr>
        <p:xfrm>
          <a:off x="425302" y="531628"/>
          <a:ext cx="11589489" cy="59861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4647972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FA89CFBE-FEA1-46C1-8AC3-A39B077B2F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6833819"/>
              </p:ext>
            </p:extLst>
          </p:nvPr>
        </p:nvGraphicFramePr>
        <p:xfrm>
          <a:off x="170121" y="446567"/>
          <a:ext cx="11663916" cy="59329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2046984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13C2120-2264-4C5E-880F-4D46808E07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8967862"/>
              </p:ext>
            </p:extLst>
          </p:nvPr>
        </p:nvGraphicFramePr>
        <p:xfrm>
          <a:off x="255181" y="233916"/>
          <a:ext cx="11674550" cy="6294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502780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E5DE53D9-615F-41C7-B8F4-8BF8D0F178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6187874"/>
              </p:ext>
            </p:extLst>
          </p:nvPr>
        </p:nvGraphicFramePr>
        <p:xfrm>
          <a:off x="738187" y="478464"/>
          <a:ext cx="10715626" cy="59967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3668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98796E47-FD73-4D28-9FCE-7D1DF49023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7800143"/>
              </p:ext>
            </p:extLst>
          </p:nvPr>
        </p:nvGraphicFramePr>
        <p:xfrm>
          <a:off x="127591" y="329609"/>
          <a:ext cx="11844670" cy="62838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25378654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9D53CD0-4F1D-4583-8D79-73615CE728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3266751"/>
              </p:ext>
            </p:extLst>
          </p:nvPr>
        </p:nvGraphicFramePr>
        <p:xfrm>
          <a:off x="244548" y="723014"/>
          <a:ext cx="11780875" cy="59542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00610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88</TotalTime>
  <Words>667</Words>
  <Application>Microsoft Office PowerPoint</Application>
  <PresentationFormat>Widescreen</PresentationFormat>
  <Paragraphs>31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elo Seatla</dc:creator>
  <cp:lastModifiedBy>Kaelo Seatla</cp:lastModifiedBy>
  <cp:revision>82</cp:revision>
  <cp:lastPrinted>2021-03-22T08:30:11Z</cp:lastPrinted>
  <dcterms:created xsi:type="dcterms:W3CDTF">2021-01-22T09:22:45Z</dcterms:created>
  <dcterms:modified xsi:type="dcterms:W3CDTF">2021-08-13T04:59:41Z</dcterms:modified>
</cp:coreProperties>
</file>